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wn Vahabzadeh, PharmD (MTM)" initials="SVP(" lastIdx="10" clrIdx="0">
    <p:extLst>
      <p:ext uri="{19B8F6BF-5375-455C-9EA6-DF929625EA0E}">
        <p15:presenceInfo xmlns:p15="http://schemas.microsoft.com/office/powerpoint/2012/main" userId="S-1-5-21-2754625900-2601979746-2412578218-11731" providerId="AD"/>
      </p:ext>
    </p:extLst>
  </p:cmAuthor>
  <p:cmAuthor id="2" name="Shawn Vahabzadeh, PharmD (MTM)" initials="SVP( [2]" lastIdx="16" clrIdx="1">
    <p:extLst>
      <p:ext uri="{19B8F6BF-5375-455C-9EA6-DF929625EA0E}">
        <p15:presenceInfo xmlns:p15="http://schemas.microsoft.com/office/powerpoint/2012/main" userId="S::Shawn.Vahabzadeh@meditechmedia.com::8407814f-7d61-4076-90b4-a45247fb421d" providerId="AD"/>
      </p:ext>
    </p:extLst>
  </p:cmAuthor>
  <p:cmAuthor id="3" name="Mihaela Marina, PhD (MTM)" initials="MMP(" lastIdx="2" clrIdx="2">
    <p:extLst>
      <p:ext uri="{19B8F6BF-5375-455C-9EA6-DF929625EA0E}">
        <p15:presenceInfo xmlns:p15="http://schemas.microsoft.com/office/powerpoint/2012/main" userId="S::Mihaela.Marina@meditechmedia.com::7d92716a-fcf1-4ee5-8b29-5c80102b01ec" providerId="AD"/>
      </p:ext>
    </p:extLst>
  </p:cmAuthor>
  <p:cmAuthor id="4" name="Kerry Garza, PhD (MTM)" initials="KGP(" lastIdx="1" clrIdx="3">
    <p:extLst>
      <p:ext uri="{19B8F6BF-5375-455C-9EA6-DF929625EA0E}">
        <p15:presenceInfo xmlns:p15="http://schemas.microsoft.com/office/powerpoint/2012/main" userId="S::Kerry.Garza@meditechmedia.com::f4e76a70-b598-4fb8-9249-00fb37dcbcf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62" d="100"/>
          <a:sy n="162" d="100"/>
        </p:scale>
        <p:origin x="26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CF7B04-DB20-4F80-BC0B-BE73FC1FF19B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4D31DB-BDA9-4411-A6B4-DA8E30374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402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0F2F8-8EDC-49FC-8241-ED911DEA46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274BE0-9E6C-4E16-8737-26911C16BF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779BA7-1D7E-4FC7-9802-232CC18B6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76F9E-C824-4E91-9540-C0F604E9A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CFB0A0-82A8-44F2-91B1-0E3DC0077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522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2BC04-51C1-4C7A-B0C9-3B29161D3A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3DB4C4-BD54-4A84-87C9-74E7EBB719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FB588C-B6BE-4CD1-AC13-BD5068F31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D7306C-A1A6-4443-9800-FDBF53C31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52C82-C0C4-439B-AB00-730BE6034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445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F834FF-4EBD-4FAB-955A-6295CED360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A6C2CF-15DE-4302-9BCF-4D12EF2DBD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13713-FEBC-45BA-9BE1-F33222BD3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D4430-032A-4ED7-9DE4-22ED13BFE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B55C2B-6700-4193-99E2-28DC04B50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215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0AD3A-FEED-4E19-9E35-132E1EA02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7342AF-3B19-4EC3-91A7-DDA84EDCAD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448CE-73F9-47D3-96F8-81C8D79A7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1B96F-E8A3-4B54-A0A4-60F4D0861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56346-E2EC-4C8B-992F-F45993CFE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14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2A1035-750D-48CC-A966-C02C2C37D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356EE-F460-4CE2-8150-55B8019B8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84991-69AD-4BEA-97E7-2398040BE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1FF1DE-E32F-42EE-A098-EB728B73E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A45F1-8F16-45DB-8C7F-E580259B4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47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6FDAA-BD01-4A3C-9937-8B8EC440A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7BB6C7-C538-4C9F-B38E-73EF57010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9D1F4F-0916-43DB-95A2-6E82D86170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B4D148-4AB4-4FB1-BFEC-FC894CFED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9B4010-C9CD-486C-8C1C-85A86D4B0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F6E868-F1F2-43F1-AE00-4931C25C7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206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44B9BD-3A56-4568-8D94-A56775B17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658F85-C64D-4B50-B2A4-028186408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4E9A08-04DB-4AB6-8E11-68684487D8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1DA1D6-6A0D-4565-AF93-2CD893EAF3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751BBA-6380-4631-B09D-E04DF7CC48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A0F4E2-3289-4180-9729-114937A9C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077B10-67B4-4B35-9E45-9DE9DF216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3F01D2-0FDD-45A6-943D-98D039DC3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744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EDB2D0-EC6E-4C14-B176-4B79FDA690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DD6F7E-A9ED-4557-BB7E-E81DACB15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281D85-1568-4F8B-A7AC-05387FE9E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922F02-18CF-4C31-A96D-69F74FC2B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47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46232E-5ED5-4129-90C9-6C2E2F504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C44D1F-734B-41C7-8A28-C4F111053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2524A9-F1D0-4A52-84F4-882F6B9CD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07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6B691-ACA6-4739-894C-0AACBA40D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E00E4-CB86-441A-B7E2-9651EDBF95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EC724B-ADE1-456D-8641-6D2F07413B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66277A-028B-4F3B-B640-B79856C21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AE577F-B0AC-4EC1-8B5A-AB653D621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FDB6B-D020-457F-93E3-3A47CACDF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10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13530-847B-4EA5-B525-826E90063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670428-8077-484F-AF6A-A6DAD4AD55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0FAE95-3E50-4529-9F33-A3F5F7FB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EA920-0AE0-4FFF-B5BA-0F3C2FC6C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B7295-58FE-4167-82AD-5BDF1FA6B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100CAF-FB30-42E6-9C8F-629A3D698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471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90FB55-2BED-4098-8A24-61DFF2047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E1CC5D-E3B0-4B04-A475-B16B546E74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64E550-4BE0-4B41-A1B1-3DF5DFCAA2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4B1B3-A1DD-4859-92C9-5673F9F03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66C937-234E-4EF6-AC65-93D4C0B321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7" name="Group 186">
            <a:extLst>
              <a:ext uri="{FF2B5EF4-FFF2-40B4-BE49-F238E27FC236}">
                <a16:creationId xmlns:a16="http://schemas.microsoft.com/office/drawing/2014/main" id="{5C80A576-D2A7-4C33-B536-433A4CE80EB4}"/>
              </a:ext>
            </a:extLst>
          </p:cNvPr>
          <p:cNvGrpSpPr/>
          <p:nvPr/>
        </p:nvGrpSpPr>
        <p:grpSpPr>
          <a:xfrm>
            <a:off x="3627438" y="1463675"/>
            <a:ext cx="5608638" cy="3116263"/>
            <a:chOff x="3627438" y="1463675"/>
            <a:chExt cx="5608638" cy="3116263"/>
          </a:xfrm>
        </p:grpSpPr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0AFF3BC6-B05A-4E8C-AB62-F2A3DFFF6A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81413" y="2990850"/>
              <a:ext cx="5554663" cy="0"/>
            </a:xfrm>
            <a:prstGeom prst="line">
              <a:avLst/>
            </a:prstGeom>
            <a:noFill/>
            <a:ln w="14351" cap="flat">
              <a:solidFill>
                <a:schemeClr val="tx1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86" name="Group 185">
              <a:extLst>
                <a:ext uri="{FF2B5EF4-FFF2-40B4-BE49-F238E27FC236}">
                  <a16:creationId xmlns:a16="http://schemas.microsoft.com/office/drawing/2014/main" id="{5CBECDD5-463D-476E-B1AF-A3E662112C97}"/>
                </a:ext>
              </a:extLst>
            </p:cNvPr>
            <p:cNvGrpSpPr/>
            <p:nvPr/>
          </p:nvGrpSpPr>
          <p:grpSpPr>
            <a:xfrm>
              <a:off x="3627438" y="1463675"/>
              <a:ext cx="5608638" cy="3116263"/>
              <a:chOff x="3627438" y="1463675"/>
              <a:chExt cx="5608638" cy="3116263"/>
            </a:xfrm>
          </p:grpSpPr>
          <p:sp>
            <p:nvSpPr>
              <p:cNvPr id="9" name="Line 6">
                <a:extLst>
                  <a:ext uri="{FF2B5EF4-FFF2-40B4-BE49-F238E27FC236}">
                    <a16:creationId xmlns:a16="http://schemas.microsoft.com/office/drawing/2014/main" id="{3F8865A9-CD03-4ADA-A864-23A5C66A1C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4462463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Line 7">
                <a:extLst>
                  <a:ext uri="{FF2B5EF4-FFF2-40B4-BE49-F238E27FC236}">
                    <a16:creationId xmlns:a16="http://schemas.microsoft.com/office/drawing/2014/main" id="{01D414FA-4C36-400D-B6F2-BF7D5C5C5C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3876675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Line 8">
                <a:extLst>
                  <a:ext uri="{FF2B5EF4-FFF2-40B4-BE49-F238E27FC236}">
                    <a16:creationId xmlns:a16="http://schemas.microsoft.com/office/drawing/2014/main" id="{FA068430-61F5-4B3D-A4C6-138C7AB852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3290888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Line 9">
                <a:extLst>
                  <a:ext uri="{FF2B5EF4-FFF2-40B4-BE49-F238E27FC236}">
                    <a16:creationId xmlns:a16="http://schemas.microsoft.com/office/drawing/2014/main" id="{E263FA81-A84D-4178-8B63-4CE8ECF1D0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2698750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" name="Line 10">
                <a:extLst>
                  <a:ext uri="{FF2B5EF4-FFF2-40B4-BE49-F238E27FC236}">
                    <a16:creationId xmlns:a16="http://schemas.microsoft.com/office/drawing/2014/main" id="{20F28555-B9C4-4895-B60C-84236A72F7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2109788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Line 11">
                <a:extLst>
                  <a:ext uri="{FF2B5EF4-FFF2-40B4-BE49-F238E27FC236}">
                    <a16:creationId xmlns:a16="http://schemas.microsoft.com/office/drawing/2014/main" id="{502837BD-029A-40B1-B03A-2F60F2A5F5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27438" y="1524000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Line 18">
                <a:extLst>
                  <a:ext uri="{FF2B5EF4-FFF2-40B4-BE49-F238E27FC236}">
                    <a16:creationId xmlns:a16="http://schemas.microsoft.com/office/drawing/2014/main" id="{53E05CE4-B6F2-4116-B128-19289AA042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206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Line 19">
                <a:extLst>
                  <a:ext uri="{FF2B5EF4-FFF2-40B4-BE49-F238E27FC236}">
                    <a16:creationId xmlns:a16="http://schemas.microsoft.com/office/drawing/2014/main" id="{809AC010-4914-447C-A855-6C1E867BD1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306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Line 20">
                <a:extLst>
                  <a:ext uri="{FF2B5EF4-FFF2-40B4-BE49-F238E27FC236}">
                    <a16:creationId xmlns:a16="http://schemas.microsoft.com/office/drawing/2014/main" id="{F08EA5EE-9C97-4A34-A658-B3D2430838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6088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Line 21">
                <a:extLst>
                  <a:ext uri="{FF2B5EF4-FFF2-40B4-BE49-F238E27FC236}">
                    <a16:creationId xmlns:a16="http://schemas.microsoft.com/office/drawing/2014/main" id="{B493057F-77BD-48DC-B95A-4402ABFE48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40300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Line 22">
                <a:extLst>
                  <a:ext uri="{FF2B5EF4-FFF2-40B4-BE49-F238E27FC236}">
                    <a16:creationId xmlns:a16="http://schemas.microsoft.com/office/drawing/2014/main" id="{53B15508-6754-4592-AAA2-F79CA42AF4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21300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Line 23">
                <a:extLst>
                  <a:ext uri="{FF2B5EF4-FFF2-40B4-BE49-F238E27FC236}">
                    <a16:creationId xmlns:a16="http://schemas.microsoft.com/office/drawing/2014/main" id="{ADBD15FC-B890-4196-8C5C-6C10F5CD42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0071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Line 24">
                <a:extLst>
                  <a:ext uri="{FF2B5EF4-FFF2-40B4-BE49-F238E27FC236}">
                    <a16:creationId xmlns:a16="http://schemas.microsoft.com/office/drawing/2014/main" id="{E6509A3B-883C-46D3-9110-B94AF3E7EB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7853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Line 25">
                <a:extLst>
                  <a:ext uri="{FF2B5EF4-FFF2-40B4-BE49-F238E27FC236}">
                    <a16:creationId xmlns:a16="http://schemas.microsoft.com/office/drawing/2014/main" id="{B6EACA44-C35F-4427-84BA-CF5BE63F0C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953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" name="Line 26">
                <a:extLst>
                  <a:ext uri="{FF2B5EF4-FFF2-40B4-BE49-F238E27FC236}">
                    <a16:creationId xmlns:a16="http://schemas.microsoft.com/office/drawing/2014/main" id="{B9D6F3B3-F8A1-4A1F-995F-35C455629A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38950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Line 27">
                <a:extLst>
                  <a:ext uri="{FF2B5EF4-FFF2-40B4-BE49-F238E27FC236}">
                    <a16:creationId xmlns:a16="http://schemas.microsoft.com/office/drawing/2014/main" id="{960837B0-E9D7-4C45-A547-E74BCF1402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16775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Line 28">
                <a:extLst>
                  <a:ext uri="{FF2B5EF4-FFF2-40B4-BE49-F238E27FC236}">
                    <a16:creationId xmlns:a16="http://schemas.microsoft.com/office/drawing/2014/main" id="{6B707D3F-F947-4F1D-8580-7C628021CF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97775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Line 29">
                <a:extLst>
                  <a:ext uri="{FF2B5EF4-FFF2-40B4-BE49-F238E27FC236}">
                    <a16:creationId xmlns:a16="http://schemas.microsoft.com/office/drawing/2014/main" id="{8ACAE77D-EA27-4663-93E5-031CDD6302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7718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Line 30">
                <a:extLst>
                  <a:ext uri="{FF2B5EF4-FFF2-40B4-BE49-F238E27FC236}">
                    <a16:creationId xmlns:a16="http://schemas.microsoft.com/office/drawing/2014/main" id="{7DC7BC4A-22FB-4A7C-91C6-7562D5B17F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5501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Line 31">
                <a:extLst>
                  <a:ext uri="{FF2B5EF4-FFF2-40B4-BE49-F238E27FC236}">
                    <a16:creationId xmlns:a16="http://schemas.microsoft.com/office/drawing/2014/main" id="{D50872EE-3289-4020-BF53-27BA93D084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3283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Line 32">
                <a:extLst>
                  <a:ext uri="{FF2B5EF4-FFF2-40B4-BE49-F238E27FC236}">
                    <a16:creationId xmlns:a16="http://schemas.microsoft.com/office/drawing/2014/main" id="{D994F920-5DE5-4DE5-9FBD-18B4407817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15425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2" name="Line 179">
                <a:extLst>
                  <a:ext uri="{FF2B5EF4-FFF2-40B4-BE49-F238E27FC236}">
                    <a16:creationId xmlns:a16="http://schemas.microsoft.com/office/drawing/2014/main" id="{442473EB-04CD-47CE-B2A5-5A1698496D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1413" y="4519613"/>
                <a:ext cx="5554663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3" name="Line 180">
                <a:extLst>
                  <a:ext uri="{FF2B5EF4-FFF2-40B4-BE49-F238E27FC236}">
                    <a16:creationId xmlns:a16="http://schemas.microsoft.com/office/drawing/2014/main" id="{98F15F42-9EC0-4D2B-9D14-976D7B631D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81413" y="1463675"/>
                <a:ext cx="0" cy="3055938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15" name="Rectangle 12">
            <a:extLst>
              <a:ext uri="{FF2B5EF4-FFF2-40B4-BE49-F238E27FC236}">
                <a16:creationId xmlns:a16="http://schemas.microsoft.com/office/drawing/2014/main" id="{CA7C55FD-7580-42CA-BF29-9F64D733CC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3410" y="437277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16" name="Rectangle 13">
            <a:extLst>
              <a:ext uri="{FF2B5EF4-FFF2-40B4-BE49-F238E27FC236}">
                <a16:creationId xmlns:a16="http://schemas.microsoft.com/office/drawing/2014/main" id="{AB72D825-C650-4D7E-B839-1CDD0B217F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377746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6AE952F6-7B8A-436B-A159-345845FF6B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3191673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0</a:t>
            </a:r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9D430ABE-00C7-40ED-B2EF-E573129985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2605885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0</a:t>
            </a:r>
          </a:p>
        </p:txBody>
      </p:sp>
      <p:sp>
        <p:nvSpPr>
          <p:cNvPr id="19" name="Rectangle 16">
            <a:extLst>
              <a:ext uri="{FF2B5EF4-FFF2-40B4-BE49-F238E27FC236}">
                <a16:creationId xmlns:a16="http://schemas.microsoft.com/office/drawing/2014/main" id="{A635FC3F-F36A-49F3-B605-89ECA33F04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9072" y="2010573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0</a:t>
            </a:r>
          </a:p>
        </p:txBody>
      </p:sp>
      <p:sp>
        <p:nvSpPr>
          <p:cNvPr id="20" name="Rectangle 17">
            <a:extLst>
              <a:ext uri="{FF2B5EF4-FFF2-40B4-BE49-F238E27FC236}">
                <a16:creationId xmlns:a16="http://schemas.microsoft.com/office/drawing/2014/main" id="{84517035-4AB5-4BB3-AB9B-4F702F12F9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4732" y="1424785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36" name="Rectangle 33">
            <a:extLst>
              <a:ext uri="{FF2B5EF4-FFF2-40B4-BE49-F238E27FC236}">
                <a16:creationId xmlns:a16="http://schemas.microsoft.com/office/drawing/2014/main" id="{6068FCF4-0F82-4175-A2BC-6707E42930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3019" y="4875571"/>
            <a:ext cx="236007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Time Since Enrollment (months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7" name="Rectangle 34">
            <a:extLst>
              <a:ext uri="{FF2B5EF4-FFF2-40B4-BE49-F238E27FC236}">
                <a16:creationId xmlns:a16="http://schemas.microsoft.com/office/drawing/2014/main" id="{D6F5FA24-99F8-42BC-9A5C-C0A3D26C8BC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80913" y="2874706"/>
            <a:ext cx="2196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Progression-Free Survival (%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8" name="Rectangle 35">
            <a:extLst>
              <a:ext uri="{FF2B5EF4-FFF2-40B4-BE49-F238E27FC236}">
                <a16:creationId xmlns:a16="http://schemas.microsoft.com/office/drawing/2014/main" id="{B6AC551E-52D5-46B5-B442-251B6EDC6C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9893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DB81DAA0-0D78-488B-B94F-42F1997DA3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7718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</a:t>
            </a: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C20384AD-7B21-4A86-BF11-38944589ED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5543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</a:t>
            </a:r>
          </a:p>
        </p:txBody>
      </p:sp>
      <p:sp>
        <p:nvSpPr>
          <p:cNvPr id="41" name="Rectangle 38">
            <a:extLst>
              <a:ext uri="{FF2B5EF4-FFF2-40B4-BE49-F238E27FC236}">
                <a16:creationId xmlns:a16="http://schemas.microsoft.com/office/drawing/2014/main" id="{C8790D10-B4FC-4AD2-9F2B-9D37737C6A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8130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</a:t>
            </a:r>
          </a:p>
        </p:txBody>
      </p:sp>
      <p:sp>
        <p:nvSpPr>
          <p:cNvPr id="42" name="Rectangle 39">
            <a:extLst>
              <a:ext uri="{FF2B5EF4-FFF2-40B4-BE49-F238E27FC236}">
                <a16:creationId xmlns:a16="http://schemas.microsoft.com/office/drawing/2014/main" id="{0E92BC99-D50B-4AA4-AC21-02242D8270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5955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</a:t>
            </a:r>
          </a:p>
        </p:txBody>
      </p:sp>
      <p:sp>
        <p:nvSpPr>
          <p:cNvPr id="43" name="Rectangle 40">
            <a:extLst>
              <a:ext uri="{FF2B5EF4-FFF2-40B4-BE49-F238E27FC236}">
                <a16:creationId xmlns:a16="http://schemas.microsoft.com/office/drawing/2014/main" id="{63B23FA5-4AD4-472A-96AF-DD6DA59673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1611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</a:t>
            </a:r>
          </a:p>
        </p:txBody>
      </p:sp>
      <p:sp>
        <p:nvSpPr>
          <p:cNvPr id="44" name="Rectangle 41">
            <a:extLst>
              <a:ext uri="{FF2B5EF4-FFF2-40B4-BE49-F238E27FC236}">
                <a16:creationId xmlns:a16="http://schemas.microsoft.com/office/drawing/2014/main" id="{1D5E8C90-1E85-4D17-A550-AB5D3A8207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4199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2</a:t>
            </a: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5F573C4F-5EF0-4F07-9776-95EC8559C1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024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4</a:t>
            </a:r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A1036F72-A827-40DD-A41B-8EBD4D6EBC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1436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6</a:t>
            </a:r>
          </a:p>
        </p:txBody>
      </p:sp>
      <p:sp>
        <p:nvSpPr>
          <p:cNvPr id="47" name="Rectangle 44">
            <a:extLst>
              <a:ext uri="{FF2B5EF4-FFF2-40B4-BE49-F238E27FC236}">
                <a16:creationId xmlns:a16="http://schemas.microsoft.com/office/drawing/2014/main" id="{BFF34B62-50EC-451A-980E-42E4A5BCCD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2436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8</a:t>
            </a:r>
          </a:p>
        </p:txBody>
      </p:sp>
      <p:sp>
        <p:nvSpPr>
          <p:cNvPr id="48" name="Rectangle 45">
            <a:extLst>
              <a:ext uri="{FF2B5EF4-FFF2-40B4-BE49-F238E27FC236}">
                <a16:creationId xmlns:a16="http://schemas.microsoft.com/office/drawing/2014/main" id="{598FEEEE-B606-4A24-8CAE-E6DF48633F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10261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49" name="Rectangle 46">
            <a:extLst>
              <a:ext uri="{FF2B5EF4-FFF2-40B4-BE49-F238E27FC236}">
                <a16:creationId xmlns:a16="http://schemas.microsoft.com/office/drawing/2014/main" id="{711EF87E-0448-4C4E-B652-3C698AC8D4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89674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2</a:t>
            </a:r>
          </a:p>
        </p:txBody>
      </p:sp>
      <p:sp>
        <p:nvSpPr>
          <p:cNvPr id="50" name="Rectangle 47">
            <a:extLst>
              <a:ext uri="{FF2B5EF4-FFF2-40B4-BE49-F238E27FC236}">
                <a16:creationId xmlns:a16="http://schemas.microsoft.com/office/drawing/2014/main" id="{E6851623-341C-4E15-8986-5F97DC0D53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70674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4</a:t>
            </a:r>
          </a:p>
        </p:txBody>
      </p:sp>
      <p:sp>
        <p:nvSpPr>
          <p:cNvPr id="51" name="Rectangle 48">
            <a:extLst>
              <a:ext uri="{FF2B5EF4-FFF2-40B4-BE49-F238E27FC236}">
                <a16:creationId xmlns:a16="http://schemas.microsoft.com/office/drawing/2014/main" id="{9F3343BB-6594-4255-AA3F-4D94D84EC0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48499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6</a:t>
            </a:r>
          </a:p>
        </p:txBody>
      </p:sp>
      <p:sp>
        <p:nvSpPr>
          <p:cNvPr id="52" name="Rectangle 49">
            <a:extLst>
              <a:ext uri="{FF2B5EF4-FFF2-40B4-BE49-F238E27FC236}">
                <a16:creationId xmlns:a16="http://schemas.microsoft.com/office/drawing/2014/main" id="{24FCCCE3-9710-40F2-9B8C-2068A15CFC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27911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8</a:t>
            </a:r>
          </a:p>
        </p:txBody>
      </p:sp>
      <p:sp>
        <p:nvSpPr>
          <p:cNvPr id="53" name="Rectangle 50">
            <a:extLst>
              <a:ext uri="{FF2B5EF4-FFF2-40B4-BE49-F238E27FC236}">
                <a16:creationId xmlns:a16="http://schemas.microsoft.com/office/drawing/2014/main" id="{73F56A63-06EC-4632-8C9C-8C3E04E323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772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70</a:t>
            </a:r>
          </a:p>
        </p:txBody>
      </p:sp>
      <p:sp>
        <p:nvSpPr>
          <p:cNvPr id="54" name="Rectangle 51">
            <a:extLst>
              <a:ext uri="{FF2B5EF4-FFF2-40B4-BE49-F238E27FC236}">
                <a16:creationId xmlns:a16="http://schemas.microsoft.com/office/drawing/2014/main" id="{465830D3-1FD3-4C72-A499-C159D76CAE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54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2</a:t>
            </a:r>
          </a:p>
        </p:txBody>
      </p:sp>
      <p:sp>
        <p:nvSpPr>
          <p:cNvPr id="55" name="Rectangle 52">
            <a:extLst>
              <a:ext uri="{FF2B5EF4-FFF2-40B4-BE49-F238E27FC236}">
                <a16:creationId xmlns:a16="http://schemas.microsoft.com/office/drawing/2014/main" id="{F55E480A-F0BB-493F-999B-2FAF7E4FDE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337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6</a:t>
            </a:r>
          </a:p>
        </p:txBody>
      </p:sp>
      <p:sp>
        <p:nvSpPr>
          <p:cNvPr id="56" name="Rectangle 53">
            <a:extLst>
              <a:ext uri="{FF2B5EF4-FFF2-40B4-BE49-F238E27FC236}">
                <a16:creationId xmlns:a16="http://schemas.microsoft.com/office/drawing/2014/main" id="{EAA4EE79-EC92-4905-BD28-42162BDD2D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5961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5</a:t>
            </a:r>
          </a:p>
        </p:txBody>
      </p:sp>
      <p:sp>
        <p:nvSpPr>
          <p:cNvPr id="57" name="Rectangle 54">
            <a:extLst>
              <a:ext uri="{FF2B5EF4-FFF2-40B4-BE49-F238E27FC236}">
                <a16:creationId xmlns:a16="http://schemas.microsoft.com/office/drawing/2014/main" id="{5CFD0D08-FCC9-4EF8-B3D4-C35143076D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3786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58" name="Rectangle 55">
            <a:extLst>
              <a:ext uri="{FF2B5EF4-FFF2-40B4-BE49-F238E27FC236}">
                <a16:creationId xmlns:a16="http://schemas.microsoft.com/office/drawing/2014/main" id="{568E60E1-5FFF-4D87-BE42-35BD3E6ECC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1611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6</a:t>
            </a:r>
          </a:p>
        </p:txBody>
      </p:sp>
      <p:sp>
        <p:nvSpPr>
          <p:cNvPr id="59" name="Rectangle 56">
            <a:extLst>
              <a:ext uri="{FF2B5EF4-FFF2-40B4-BE49-F238E27FC236}">
                <a16:creationId xmlns:a16="http://schemas.microsoft.com/office/drawing/2014/main" id="{3F4557E6-532B-48F1-A80C-CDB7E65D00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419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3</a:t>
            </a:r>
          </a:p>
        </p:txBody>
      </p:sp>
      <p:sp>
        <p:nvSpPr>
          <p:cNvPr id="60" name="Rectangle 57">
            <a:extLst>
              <a:ext uri="{FF2B5EF4-FFF2-40B4-BE49-F238E27FC236}">
                <a16:creationId xmlns:a16="http://schemas.microsoft.com/office/drawing/2014/main" id="{1E0F274A-849D-4442-9E10-C16D08B04B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02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3</a:t>
            </a:r>
          </a:p>
        </p:txBody>
      </p:sp>
      <p:sp>
        <p:nvSpPr>
          <p:cNvPr id="61" name="Rectangle 58">
            <a:extLst>
              <a:ext uri="{FF2B5EF4-FFF2-40B4-BE49-F238E27FC236}">
                <a16:creationId xmlns:a16="http://schemas.microsoft.com/office/drawing/2014/main" id="{BC36BF25-E7C8-43C8-98ED-81AEA87F11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1436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4</a:t>
            </a:r>
          </a:p>
        </p:txBody>
      </p:sp>
      <p:sp>
        <p:nvSpPr>
          <p:cNvPr id="62" name="Rectangle 59">
            <a:extLst>
              <a:ext uri="{FF2B5EF4-FFF2-40B4-BE49-F238E27FC236}">
                <a16:creationId xmlns:a16="http://schemas.microsoft.com/office/drawing/2014/main" id="{262F7FCB-6D70-4F33-B390-3D24CA5B03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2436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4</a:t>
            </a:r>
          </a:p>
        </p:txBody>
      </p:sp>
      <p:sp>
        <p:nvSpPr>
          <p:cNvPr id="63" name="Rectangle 60">
            <a:extLst>
              <a:ext uri="{FF2B5EF4-FFF2-40B4-BE49-F238E27FC236}">
                <a16:creationId xmlns:a16="http://schemas.microsoft.com/office/drawing/2014/main" id="{D87595EB-0FF0-464A-843B-0CA222889B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2430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</a:t>
            </a:r>
          </a:p>
        </p:txBody>
      </p:sp>
      <p:sp>
        <p:nvSpPr>
          <p:cNvPr id="64" name="Rectangle 61">
            <a:extLst>
              <a:ext uri="{FF2B5EF4-FFF2-40B4-BE49-F238E27FC236}">
                <a16:creationId xmlns:a16="http://schemas.microsoft.com/office/drawing/2014/main" id="{0E488B3E-6F68-4869-BAE7-F2152FB099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31843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</a:t>
            </a:r>
          </a:p>
        </p:txBody>
      </p:sp>
      <p:sp>
        <p:nvSpPr>
          <p:cNvPr id="65" name="Rectangle 62">
            <a:extLst>
              <a:ext uri="{FF2B5EF4-FFF2-40B4-BE49-F238E27FC236}">
                <a16:creationId xmlns:a16="http://schemas.microsoft.com/office/drawing/2014/main" id="{50538446-2BB5-4624-B35C-048EE3952D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2843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</a:t>
            </a:r>
          </a:p>
        </p:txBody>
      </p:sp>
      <p:sp>
        <p:nvSpPr>
          <p:cNvPr id="66" name="Rectangle 63">
            <a:extLst>
              <a:ext uri="{FF2B5EF4-FFF2-40B4-BE49-F238E27FC236}">
                <a16:creationId xmlns:a16="http://schemas.microsoft.com/office/drawing/2014/main" id="{C4870A1F-AD78-43B6-9115-C73B1DFB61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0668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68" name="Rectangle 65">
            <a:extLst>
              <a:ext uri="{FF2B5EF4-FFF2-40B4-BE49-F238E27FC236}">
                <a16:creationId xmlns:a16="http://schemas.microsoft.com/office/drawing/2014/main" id="{67C23880-0379-4F29-92B5-57A93A32C0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7724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2</a:t>
            </a:r>
          </a:p>
        </p:txBody>
      </p:sp>
      <p:sp>
        <p:nvSpPr>
          <p:cNvPr id="69" name="Rectangle 66">
            <a:extLst>
              <a:ext uri="{FF2B5EF4-FFF2-40B4-BE49-F238E27FC236}">
                <a16:creationId xmlns:a16="http://schemas.microsoft.com/office/drawing/2014/main" id="{EF56D077-4408-4B24-8640-CEEE1B70F6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5549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7</a:t>
            </a:r>
          </a:p>
        </p:txBody>
      </p:sp>
      <p:sp>
        <p:nvSpPr>
          <p:cNvPr id="70" name="Rectangle 67">
            <a:extLst>
              <a:ext uri="{FF2B5EF4-FFF2-40B4-BE49-F238E27FC236}">
                <a16:creationId xmlns:a16="http://schemas.microsoft.com/office/drawing/2014/main" id="{0874A78B-47B3-4DB1-BBAE-08015C1358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3374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3</a:t>
            </a:r>
          </a:p>
        </p:txBody>
      </p:sp>
      <p:sp>
        <p:nvSpPr>
          <p:cNvPr id="71" name="Rectangle 68">
            <a:extLst>
              <a:ext uri="{FF2B5EF4-FFF2-40B4-BE49-F238E27FC236}">
                <a16:creationId xmlns:a16="http://schemas.microsoft.com/office/drawing/2014/main" id="{C01F621D-A06B-46A8-BA8D-03748A9006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5961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0</a:t>
            </a:r>
          </a:p>
        </p:txBody>
      </p:sp>
      <p:sp>
        <p:nvSpPr>
          <p:cNvPr id="72" name="Rectangle 69">
            <a:extLst>
              <a:ext uri="{FF2B5EF4-FFF2-40B4-BE49-F238E27FC236}">
                <a16:creationId xmlns:a16="http://schemas.microsoft.com/office/drawing/2014/main" id="{B230E4DF-5F0B-41AB-B5B5-6ECD497AA8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3786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8</a:t>
            </a:r>
          </a:p>
        </p:txBody>
      </p:sp>
      <p:sp>
        <p:nvSpPr>
          <p:cNvPr id="73" name="Rectangle 70">
            <a:extLst>
              <a:ext uri="{FF2B5EF4-FFF2-40B4-BE49-F238E27FC236}">
                <a16:creationId xmlns:a16="http://schemas.microsoft.com/office/drawing/2014/main" id="{C80D43B7-17D0-41B5-8CC4-121CF50337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1611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6</a:t>
            </a:r>
          </a:p>
        </p:txBody>
      </p:sp>
      <p:sp>
        <p:nvSpPr>
          <p:cNvPr id="74" name="Rectangle 71">
            <a:extLst>
              <a:ext uri="{FF2B5EF4-FFF2-40B4-BE49-F238E27FC236}">
                <a16:creationId xmlns:a16="http://schemas.microsoft.com/office/drawing/2014/main" id="{7CC6266A-DFD4-4FBF-9CC1-01AD8C47C6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4199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3</a:t>
            </a:r>
          </a:p>
        </p:txBody>
      </p:sp>
      <p:sp>
        <p:nvSpPr>
          <p:cNvPr id="75" name="Rectangle 72">
            <a:extLst>
              <a:ext uri="{FF2B5EF4-FFF2-40B4-BE49-F238E27FC236}">
                <a16:creationId xmlns:a16="http://schemas.microsoft.com/office/drawing/2014/main" id="{2B720515-EAC7-480B-BC93-CE84A6AD71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2024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76" name="Rectangle 73">
            <a:extLst>
              <a:ext uri="{FF2B5EF4-FFF2-40B4-BE49-F238E27FC236}">
                <a16:creationId xmlns:a16="http://schemas.microsoft.com/office/drawing/2014/main" id="{C4B6A098-B407-4205-AFF2-F8B1060F05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1436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3</a:t>
            </a:r>
          </a:p>
        </p:txBody>
      </p:sp>
      <p:sp>
        <p:nvSpPr>
          <p:cNvPr id="77" name="Rectangle 74">
            <a:extLst>
              <a:ext uri="{FF2B5EF4-FFF2-40B4-BE49-F238E27FC236}">
                <a16:creationId xmlns:a16="http://schemas.microsoft.com/office/drawing/2014/main" id="{4BF1A1EE-FF45-4D63-A80E-1B2AC778F9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2436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10</a:t>
            </a:r>
          </a:p>
        </p:txBody>
      </p:sp>
      <p:sp>
        <p:nvSpPr>
          <p:cNvPr id="78" name="Rectangle 75">
            <a:extLst>
              <a:ext uri="{FF2B5EF4-FFF2-40B4-BE49-F238E27FC236}">
                <a16:creationId xmlns:a16="http://schemas.microsoft.com/office/drawing/2014/main" id="{E7518406-4AFA-41B6-AA85-5C7AF99A05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2430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</a:t>
            </a:r>
          </a:p>
        </p:txBody>
      </p:sp>
      <p:sp>
        <p:nvSpPr>
          <p:cNvPr id="79" name="Rectangle 76">
            <a:extLst>
              <a:ext uri="{FF2B5EF4-FFF2-40B4-BE49-F238E27FC236}">
                <a16:creationId xmlns:a16="http://schemas.microsoft.com/office/drawing/2014/main" id="{764F2095-1BBC-4C05-957D-6AD4804CFE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31843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80" name="Rectangle 77">
            <a:extLst>
              <a:ext uri="{FF2B5EF4-FFF2-40B4-BE49-F238E27FC236}">
                <a16:creationId xmlns:a16="http://schemas.microsoft.com/office/drawing/2014/main" id="{6EB63FD3-7F6D-4A34-818D-BF9A9ECAFF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12843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81" name="Rectangle 78">
            <a:extLst>
              <a:ext uri="{FF2B5EF4-FFF2-40B4-BE49-F238E27FC236}">
                <a16:creationId xmlns:a16="http://schemas.microsoft.com/office/drawing/2014/main" id="{5DB14A3C-C295-4ECF-B3C9-6B2188EB18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90668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82" name="Rectangle 79">
            <a:extLst>
              <a:ext uri="{FF2B5EF4-FFF2-40B4-BE49-F238E27FC236}">
                <a16:creationId xmlns:a16="http://schemas.microsoft.com/office/drawing/2014/main" id="{7F9D59E7-5FA3-4875-BF56-497B842375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70080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83" name="Rectangle 80">
            <a:extLst>
              <a:ext uri="{FF2B5EF4-FFF2-40B4-BE49-F238E27FC236}">
                <a16:creationId xmlns:a16="http://schemas.microsoft.com/office/drawing/2014/main" id="{29EF46F2-849D-4E4C-B9CC-B9A87118D9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1988" y="1606550"/>
            <a:ext cx="106279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One Prior Lin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81">
            <a:extLst>
              <a:ext uri="{FF2B5EF4-FFF2-40B4-BE49-F238E27FC236}">
                <a16:creationId xmlns:a16="http://schemas.microsoft.com/office/drawing/2014/main" id="{BF5F61BC-8971-4A99-90A4-970BE1ADBD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1988" y="1808163"/>
            <a:ext cx="114595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Two Prior Lines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5" name="Rectangle 82">
            <a:extLst>
              <a:ext uri="{FF2B5EF4-FFF2-40B4-BE49-F238E27FC236}">
                <a16:creationId xmlns:a16="http://schemas.microsoft.com/office/drawing/2014/main" id="{22942F90-70A6-4183-8B61-93AC3ADB4E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9744" y="5196601"/>
            <a:ext cx="98905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One Prior Line</a:t>
            </a:r>
          </a:p>
        </p:txBody>
      </p:sp>
      <p:sp>
        <p:nvSpPr>
          <p:cNvPr id="86" name="Rectangle 83">
            <a:extLst>
              <a:ext uri="{FF2B5EF4-FFF2-40B4-BE49-F238E27FC236}">
                <a16:creationId xmlns:a16="http://schemas.microsoft.com/office/drawing/2014/main" id="{DB28D965-26DE-4C8B-AA0D-30B02DE5A9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1263" y="5416382"/>
            <a:ext cx="10575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Two Prior Lines</a:t>
            </a:r>
          </a:p>
        </p:txBody>
      </p:sp>
      <p:sp>
        <p:nvSpPr>
          <p:cNvPr id="87" name="Line 84">
            <a:extLst>
              <a:ext uri="{FF2B5EF4-FFF2-40B4-BE49-F238E27FC236}">
                <a16:creationId xmlns:a16="http://schemas.microsoft.com/office/drawing/2014/main" id="{80E239A1-D7D5-4F75-A54D-85746004EBE9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3213" y="1689100"/>
            <a:ext cx="304800" cy="0"/>
          </a:xfrm>
          <a:prstGeom prst="line">
            <a:avLst/>
          </a:prstGeom>
          <a:noFill/>
          <a:ln w="1905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8" name="Line 85">
            <a:extLst>
              <a:ext uri="{FF2B5EF4-FFF2-40B4-BE49-F238E27FC236}">
                <a16:creationId xmlns:a16="http://schemas.microsoft.com/office/drawing/2014/main" id="{B68F9BC8-B957-4930-BDBC-37C5375802B2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9563" y="1893888"/>
            <a:ext cx="304800" cy="0"/>
          </a:xfrm>
          <a:prstGeom prst="line">
            <a:avLst/>
          </a:prstGeom>
          <a:noFill/>
          <a:ln w="19050" cap="flat">
            <a:solidFill>
              <a:srgbClr val="0000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B56514D7-A25D-4825-AB67-2B22F9B3E407}"/>
              </a:ext>
            </a:extLst>
          </p:cNvPr>
          <p:cNvGrpSpPr/>
          <p:nvPr/>
        </p:nvGrpSpPr>
        <p:grpSpPr>
          <a:xfrm>
            <a:off x="3802063" y="1501775"/>
            <a:ext cx="4870450" cy="1438275"/>
            <a:chOff x="3802063" y="1501775"/>
            <a:chExt cx="4870450" cy="1438275"/>
          </a:xfrm>
        </p:grpSpPr>
        <p:grpSp>
          <p:nvGrpSpPr>
            <p:cNvPr id="190" name="Group 189">
              <a:extLst>
                <a:ext uri="{FF2B5EF4-FFF2-40B4-BE49-F238E27FC236}">
                  <a16:creationId xmlns:a16="http://schemas.microsoft.com/office/drawing/2014/main" id="{23A16926-487F-45DA-9798-9FD6C340BE3A}"/>
                </a:ext>
              </a:extLst>
            </p:cNvPr>
            <p:cNvGrpSpPr/>
            <p:nvPr/>
          </p:nvGrpSpPr>
          <p:grpSpPr>
            <a:xfrm>
              <a:off x="3900488" y="1501775"/>
              <a:ext cx="4772025" cy="1438275"/>
              <a:chOff x="3900488" y="1501775"/>
              <a:chExt cx="4772025" cy="1438275"/>
            </a:xfrm>
          </p:grpSpPr>
          <p:sp>
            <p:nvSpPr>
              <p:cNvPr id="91" name="Line 88">
                <a:extLst>
                  <a:ext uri="{FF2B5EF4-FFF2-40B4-BE49-F238E27FC236}">
                    <a16:creationId xmlns:a16="http://schemas.microsoft.com/office/drawing/2014/main" id="{E51F4287-7A7D-49DD-AD76-E4730C14BE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0488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Line 89">
                <a:extLst>
                  <a:ext uri="{FF2B5EF4-FFF2-40B4-BE49-F238E27FC236}">
                    <a16:creationId xmlns:a16="http://schemas.microsoft.com/office/drawing/2014/main" id="{1881EE81-B749-4D38-BBED-AD6306018A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67163" y="1651000"/>
                <a:ext cx="2540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Line 90">
                <a:extLst>
                  <a:ext uri="{FF2B5EF4-FFF2-40B4-BE49-F238E27FC236}">
                    <a16:creationId xmlns:a16="http://schemas.microsoft.com/office/drawing/2014/main" id="{8ABE7A56-99F5-4511-8BFF-EB519026EC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9863" y="1638300"/>
                <a:ext cx="0" cy="2540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Line 91">
                <a:extLst>
                  <a:ext uri="{FF2B5EF4-FFF2-40B4-BE49-F238E27FC236}">
                    <a16:creationId xmlns:a16="http://schemas.microsoft.com/office/drawing/2014/main" id="{EBCB5093-3F87-49F8-AC1D-B14F463BAC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57638" y="165100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5" name="Line 92">
                <a:extLst>
                  <a:ext uri="{FF2B5EF4-FFF2-40B4-BE49-F238E27FC236}">
                    <a16:creationId xmlns:a16="http://schemas.microsoft.com/office/drawing/2014/main" id="{834CA078-A9DC-48F3-9651-978A840E86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9863" y="1628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Line 93">
                <a:extLst>
                  <a:ext uri="{FF2B5EF4-FFF2-40B4-BE49-F238E27FC236}">
                    <a16:creationId xmlns:a16="http://schemas.microsoft.com/office/drawing/2014/main" id="{CD16BA13-53F1-4F14-ABAF-4CEF498CC0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310063" y="1736725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7" name="Line 94">
                <a:extLst>
                  <a:ext uri="{FF2B5EF4-FFF2-40B4-BE49-F238E27FC236}">
                    <a16:creationId xmlns:a16="http://schemas.microsoft.com/office/drawing/2014/main" id="{1C33A93F-1F6B-4C25-A1DC-4E98A66465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32288" y="17145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Line 95">
                <a:extLst>
                  <a:ext uri="{FF2B5EF4-FFF2-40B4-BE49-F238E27FC236}">
                    <a16:creationId xmlns:a16="http://schemas.microsoft.com/office/drawing/2014/main" id="{A2FCE132-ED5A-48EC-8168-4F674A345E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24363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Line 96">
                <a:extLst>
                  <a:ext uri="{FF2B5EF4-FFF2-40B4-BE49-F238E27FC236}">
                    <a16:creationId xmlns:a16="http://schemas.microsoft.com/office/drawing/2014/main" id="{BFF3DEC3-FA78-49A5-946C-92DA6B1D76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43413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Line 97">
                <a:extLst>
                  <a:ext uri="{FF2B5EF4-FFF2-40B4-BE49-F238E27FC236}">
                    <a16:creationId xmlns:a16="http://schemas.microsoft.com/office/drawing/2014/main" id="{1BE13FEA-85B8-42A9-A883-BC8DBCB9F1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29138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Line 98">
                <a:extLst>
                  <a:ext uri="{FF2B5EF4-FFF2-40B4-BE49-F238E27FC236}">
                    <a16:creationId xmlns:a16="http://schemas.microsoft.com/office/drawing/2014/main" id="{A669DC91-5897-4954-A19C-BD42E381B9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4575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Line 99">
                <a:extLst>
                  <a:ext uri="{FF2B5EF4-FFF2-40B4-BE49-F238E27FC236}">
                    <a16:creationId xmlns:a16="http://schemas.microsoft.com/office/drawing/2014/main" id="{742CCFF5-3801-4854-B08D-70AB81713D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35550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Line 100">
                <a:extLst>
                  <a:ext uri="{FF2B5EF4-FFF2-40B4-BE49-F238E27FC236}">
                    <a16:creationId xmlns:a16="http://schemas.microsoft.com/office/drawing/2014/main" id="{B4730627-BB7E-4D99-B437-69090B5A26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59375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Line 101">
                <a:extLst>
                  <a:ext uri="{FF2B5EF4-FFF2-40B4-BE49-F238E27FC236}">
                    <a16:creationId xmlns:a16="http://schemas.microsoft.com/office/drawing/2014/main" id="{91525463-9FDD-4EA2-9956-A010577657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72075" y="178435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Line 102">
                <a:extLst>
                  <a:ext uri="{FF2B5EF4-FFF2-40B4-BE49-F238E27FC236}">
                    <a16:creationId xmlns:a16="http://schemas.microsoft.com/office/drawing/2014/main" id="{797F7A5D-C33E-408C-9278-5247D909C8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4300" y="1762125"/>
                <a:ext cx="0" cy="49213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Line 103">
                <a:extLst>
                  <a:ext uri="{FF2B5EF4-FFF2-40B4-BE49-F238E27FC236}">
                    <a16:creationId xmlns:a16="http://schemas.microsoft.com/office/drawing/2014/main" id="{D84C9EC8-C72A-4CCD-B0F1-C9D5EC6E78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97563" y="212566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Line 104">
                <a:extLst>
                  <a:ext uri="{FF2B5EF4-FFF2-40B4-BE49-F238E27FC236}">
                    <a16:creationId xmlns:a16="http://schemas.microsoft.com/office/drawing/2014/main" id="{7B1F9053-0D5C-4701-9191-0DC77B6CC6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83288" y="212566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Line 105">
                <a:extLst>
                  <a:ext uri="{FF2B5EF4-FFF2-40B4-BE49-F238E27FC236}">
                    <a16:creationId xmlns:a16="http://schemas.microsoft.com/office/drawing/2014/main" id="{B68B5EFB-BE6A-435C-9B87-99E063E9F8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69038" y="223361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Line 106">
                <a:extLst>
                  <a:ext uri="{FF2B5EF4-FFF2-40B4-BE49-F238E27FC236}">
                    <a16:creationId xmlns:a16="http://schemas.microsoft.com/office/drawing/2014/main" id="{91B2051F-DAA4-412C-82FE-C82CF6319E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88088" y="223361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Line 107">
                <a:extLst>
                  <a:ext uri="{FF2B5EF4-FFF2-40B4-BE49-F238E27FC236}">
                    <a16:creationId xmlns:a16="http://schemas.microsoft.com/office/drawing/2014/main" id="{245E370E-5898-42D6-9592-0B4395E249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54763" y="2312988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Line 108">
                <a:extLst>
                  <a:ext uri="{FF2B5EF4-FFF2-40B4-BE49-F238E27FC236}">
                    <a16:creationId xmlns:a16="http://schemas.microsoft.com/office/drawing/2014/main" id="{D6B0DDEA-6522-49A5-90CA-C341850A3A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80163" y="22875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Line 109">
                <a:extLst>
                  <a:ext uri="{FF2B5EF4-FFF2-40B4-BE49-F238E27FC236}">
                    <a16:creationId xmlns:a16="http://schemas.microsoft.com/office/drawing/2014/main" id="{133FC68E-2FB8-4253-8164-1F34AFD976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15088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Line 110">
                <a:extLst>
                  <a:ext uri="{FF2B5EF4-FFF2-40B4-BE49-F238E27FC236}">
                    <a16:creationId xmlns:a16="http://schemas.microsoft.com/office/drawing/2014/main" id="{A8C04211-585D-4DA6-A1F4-12771EFF33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1438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Line 111">
                <a:extLst>
                  <a:ext uri="{FF2B5EF4-FFF2-40B4-BE49-F238E27FC236}">
                    <a16:creationId xmlns:a16="http://schemas.microsoft.com/office/drawing/2014/main" id="{B38455C9-C08F-4476-BBCC-AD7A587D80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34138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Line 112">
                <a:extLst>
                  <a:ext uri="{FF2B5EF4-FFF2-40B4-BE49-F238E27FC236}">
                    <a16:creationId xmlns:a16="http://schemas.microsoft.com/office/drawing/2014/main" id="{11F03DED-1014-48BA-8916-E26C77EC24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9538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Line 113">
                <a:extLst>
                  <a:ext uri="{FF2B5EF4-FFF2-40B4-BE49-F238E27FC236}">
                    <a16:creationId xmlns:a16="http://schemas.microsoft.com/office/drawing/2014/main" id="{0800EB39-9BB1-475A-8FF0-328182952A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94463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Line 114">
                <a:extLst>
                  <a:ext uri="{FF2B5EF4-FFF2-40B4-BE49-F238E27FC236}">
                    <a16:creationId xmlns:a16="http://schemas.microsoft.com/office/drawing/2014/main" id="{CD8D7D4A-8F03-4F19-878A-65A6FA3171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1938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Line 115">
                <a:extLst>
                  <a:ext uri="{FF2B5EF4-FFF2-40B4-BE49-F238E27FC236}">
                    <a16:creationId xmlns:a16="http://schemas.microsoft.com/office/drawing/2014/main" id="{27143F1C-D7EF-4637-AB90-42D0CD6EC1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21463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Line 116">
                <a:extLst>
                  <a:ext uri="{FF2B5EF4-FFF2-40B4-BE49-F238E27FC236}">
                    <a16:creationId xmlns:a16="http://schemas.microsoft.com/office/drawing/2014/main" id="{8DC4F9CA-B23A-49D3-9C8D-962A34187A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46863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Line 117">
                <a:extLst>
                  <a:ext uri="{FF2B5EF4-FFF2-40B4-BE49-F238E27FC236}">
                    <a16:creationId xmlns:a16="http://schemas.microsoft.com/office/drawing/2014/main" id="{AF71D536-4617-4F4F-B246-DBE92CD3FE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59575" y="2366963"/>
                <a:ext cx="222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Line 118">
                <a:extLst>
                  <a:ext uri="{FF2B5EF4-FFF2-40B4-BE49-F238E27FC236}">
                    <a16:creationId xmlns:a16="http://schemas.microsoft.com/office/drawing/2014/main" id="{7000F248-2913-4C80-A1EC-E9988D1F02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6910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Line 119">
                <a:extLst>
                  <a:ext uri="{FF2B5EF4-FFF2-40B4-BE49-F238E27FC236}">
                    <a16:creationId xmlns:a16="http://schemas.microsoft.com/office/drawing/2014/main" id="{AED9A6DC-D4A5-41E1-92FD-84818214E6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6910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Line 120">
                <a:extLst>
                  <a:ext uri="{FF2B5EF4-FFF2-40B4-BE49-F238E27FC236}">
                    <a16:creationId xmlns:a16="http://schemas.microsoft.com/office/drawing/2014/main" id="{415727F7-CE7C-4E35-880E-C2FB15BB1B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7545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Line 121">
                <a:extLst>
                  <a:ext uri="{FF2B5EF4-FFF2-40B4-BE49-F238E27FC236}">
                    <a16:creationId xmlns:a16="http://schemas.microsoft.com/office/drawing/2014/main" id="{553223D1-BA2B-4532-B2C5-D6697811D3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8815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Line 122">
                <a:extLst>
                  <a:ext uri="{FF2B5EF4-FFF2-40B4-BE49-F238E27FC236}">
                    <a16:creationId xmlns:a16="http://schemas.microsoft.com/office/drawing/2014/main" id="{407BED1D-AAAC-46BD-887D-39F9BDAB5A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54825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Line 123">
                <a:extLst>
                  <a:ext uri="{FF2B5EF4-FFF2-40B4-BE49-F238E27FC236}">
                    <a16:creationId xmlns:a16="http://schemas.microsoft.com/office/drawing/2014/main" id="{F917FF70-9D47-4467-B120-21642D7D34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61175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Line 124">
                <a:extLst>
                  <a:ext uri="{FF2B5EF4-FFF2-40B4-BE49-F238E27FC236}">
                    <a16:creationId xmlns:a16="http://schemas.microsoft.com/office/drawing/2014/main" id="{AACCBE67-51D8-4C0B-8978-9BC51AA0FC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67525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Line 125">
                <a:extLst>
                  <a:ext uri="{FF2B5EF4-FFF2-40B4-BE49-F238E27FC236}">
                    <a16:creationId xmlns:a16="http://schemas.microsoft.com/office/drawing/2014/main" id="{001640C4-8B17-43B7-A33D-2FA65CAFCB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11975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Line 126">
                <a:extLst>
                  <a:ext uri="{FF2B5EF4-FFF2-40B4-BE49-F238E27FC236}">
                    <a16:creationId xmlns:a16="http://schemas.microsoft.com/office/drawing/2014/main" id="{957C2835-804E-4DEE-B132-B8B56E2FF7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2150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" name="Line 127">
                <a:extLst>
                  <a:ext uri="{FF2B5EF4-FFF2-40B4-BE49-F238E27FC236}">
                    <a16:creationId xmlns:a16="http://schemas.microsoft.com/office/drawing/2014/main" id="{8A67F504-E7D6-4CAC-84DB-24AD4D67D0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690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Line 128">
                <a:extLst>
                  <a:ext uri="{FF2B5EF4-FFF2-40B4-BE49-F238E27FC236}">
                    <a16:creationId xmlns:a16="http://schemas.microsoft.com/office/drawing/2014/main" id="{529F76D1-4B0A-400A-95D2-976A76B682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5325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Line 129">
                <a:extLst>
                  <a:ext uri="{FF2B5EF4-FFF2-40B4-BE49-F238E27FC236}">
                    <a16:creationId xmlns:a16="http://schemas.microsoft.com/office/drawing/2014/main" id="{0446BC10-D257-40FD-A5F4-65CBF09660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200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Line 130">
                <a:extLst>
                  <a:ext uri="{FF2B5EF4-FFF2-40B4-BE49-F238E27FC236}">
                    <a16:creationId xmlns:a16="http://schemas.microsoft.com/office/drawing/2014/main" id="{E2EB7045-AAFF-4F8A-B893-FD64C42CBF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4375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" name="Line 131">
                <a:extLst>
                  <a:ext uri="{FF2B5EF4-FFF2-40B4-BE49-F238E27FC236}">
                    <a16:creationId xmlns:a16="http://schemas.microsoft.com/office/drawing/2014/main" id="{4BD41D76-F82D-4016-AACB-C4493A51B9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10425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Line 132">
                <a:extLst>
                  <a:ext uri="{FF2B5EF4-FFF2-40B4-BE49-F238E27FC236}">
                    <a16:creationId xmlns:a16="http://schemas.microsoft.com/office/drawing/2014/main" id="{770AE418-0C1B-4156-8C2A-A0D8D0E910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96150" y="23447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" name="Line 133">
                <a:extLst>
                  <a:ext uri="{FF2B5EF4-FFF2-40B4-BE49-F238E27FC236}">
                    <a16:creationId xmlns:a16="http://schemas.microsoft.com/office/drawing/2014/main" id="{4E2C7D20-3222-48FB-974D-FE390801CD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3475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" name="Line 134">
                <a:extLst>
                  <a:ext uri="{FF2B5EF4-FFF2-40B4-BE49-F238E27FC236}">
                    <a16:creationId xmlns:a16="http://schemas.microsoft.com/office/drawing/2014/main" id="{4ED88AD2-B723-4FCD-AB50-89D0FA4338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15225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" name="Line 135">
                <a:extLst>
                  <a:ext uri="{FF2B5EF4-FFF2-40B4-BE49-F238E27FC236}">
                    <a16:creationId xmlns:a16="http://schemas.microsoft.com/office/drawing/2014/main" id="{42BB4143-9FE0-4D3B-877E-03D17BAB45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21575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" name="Line 136">
                <a:extLst>
                  <a:ext uri="{FF2B5EF4-FFF2-40B4-BE49-F238E27FC236}">
                    <a16:creationId xmlns:a16="http://schemas.microsoft.com/office/drawing/2014/main" id="{D5815744-7C58-421A-8681-EDFBC15B64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56500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" name="Line 137">
                <a:extLst>
                  <a:ext uri="{FF2B5EF4-FFF2-40B4-BE49-F238E27FC236}">
                    <a16:creationId xmlns:a16="http://schemas.microsoft.com/office/drawing/2014/main" id="{9E720ECD-386D-4061-BA86-67C2A88E9D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42225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" name="Line 138">
                <a:extLst>
                  <a:ext uri="{FF2B5EF4-FFF2-40B4-BE49-F238E27FC236}">
                    <a16:creationId xmlns:a16="http://schemas.microsoft.com/office/drawing/2014/main" id="{5FDC552F-6EEA-4892-8DBA-97E0F48847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83500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" name="Line 139">
                <a:extLst>
                  <a:ext uri="{FF2B5EF4-FFF2-40B4-BE49-F238E27FC236}">
                    <a16:creationId xmlns:a16="http://schemas.microsoft.com/office/drawing/2014/main" id="{2D869D4A-8641-4E60-A324-241F8BBE13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43838" y="25082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" name="Line 140">
                <a:extLst>
                  <a:ext uri="{FF2B5EF4-FFF2-40B4-BE49-F238E27FC236}">
                    <a16:creationId xmlns:a16="http://schemas.microsoft.com/office/drawing/2014/main" id="{5AD4DA26-2E92-4469-8185-EECC472453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980363" y="2917825"/>
                <a:ext cx="222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" name="Line 141">
                <a:extLst>
                  <a:ext uri="{FF2B5EF4-FFF2-40B4-BE49-F238E27FC236}">
                    <a16:creationId xmlns:a16="http://schemas.microsoft.com/office/drawing/2014/main" id="{638C2748-323D-4D61-8E7B-F29BD53854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89888" y="2905125"/>
                <a:ext cx="0" cy="222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Line 142">
                <a:extLst>
                  <a:ext uri="{FF2B5EF4-FFF2-40B4-BE49-F238E27FC236}">
                    <a16:creationId xmlns:a16="http://schemas.microsoft.com/office/drawing/2014/main" id="{7AF23A93-4EFA-4208-99CF-C0C95DC1CC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89888" y="289242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" name="Line 143">
                <a:extLst>
                  <a:ext uri="{FF2B5EF4-FFF2-40B4-BE49-F238E27FC236}">
                    <a16:creationId xmlns:a16="http://schemas.microsoft.com/office/drawing/2014/main" id="{FE2067E8-A701-47BA-959D-DEAECC9F30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26413" y="289242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Line 144">
                <a:extLst>
                  <a:ext uri="{FF2B5EF4-FFF2-40B4-BE49-F238E27FC236}">
                    <a16:creationId xmlns:a16="http://schemas.microsoft.com/office/drawing/2014/main" id="{7CEB5590-092E-4E6C-9386-17B0C6AA4C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28063" y="2917825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" name="Line 145">
                <a:extLst>
                  <a:ext uri="{FF2B5EF4-FFF2-40B4-BE49-F238E27FC236}">
                    <a16:creationId xmlns:a16="http://schemas.microsoft.com/office/drawing/2014/main" id="{5CBD6F38-BCBF-4E98-A249-84481DC620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0288" y="289242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84" name="Freeform 181">
              <a:extLst>
                <a:ext uri="{FF2B5EF4-FFF2-40B4-BE49-F238E27FC236}">
                  <a16:creationId xmlns:a16="http://schemas.microsoft.com/office/drawing/2014/main" id="{EB181E33-C6F4-400C-809A-F755054186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2063" y="1524000"/>
              <a:ext cx="4848225" cy="1393825"/>
            </a:xfrm>
            <a:custGeom>
              <a:avLst/>
              <a:gdLst>
                <a:gd name="T0" fmla="*/ 4 w 3054"/>
                <a:gd name="T1" fmla="*/ 0 h 878"/>
                <a:gd name="T2" fmla="*/ 74 w 3054"/>
                <a:gd name="T3" fmla="*/ 0 h 878"/>
                <a:gd name="T4" fmla="*/ 104 w 3054"/>
                <a:gd name="T5" fmla="*/ 26 h 878"/>
                <a:gd name="T6" fmla="*/ 108 w 3054"/>
                <a:gd name="T7" fmla="*/ 54 h 878"/>
                <a:gd name="T8" fmla="*/ 112 w 3054"/>
                <a:gd name="T9" fmla="*/ 80 h 878"/>
                <a:gd name="T10" fmla="*/ 120 w 3054"/>
                <a:gd name="T11" fmla="*/ 108 h 878"/>
                <a:gd name="T12" fmla="*/ 254 w 3054"/>
                <a:gd name="T13" fmla="*/ 134 h 878"/>
                <a:gd name="T14" fmla="*/ 338 w 3054"/>
                <a:gd name="T15" fmla="*/ 134 h 878"/>
                <a:gd name="T16" fmla="*/ 392 w 3054"/>
                <a:gd name="T17" fmla="*/ 164 h 878"/>
                <a:gd name="T18" fmla="*/ 458 w 3054"/>
                <a:gd name="T19" fmla="*/ 164 h 878"/>
                <a:gd name="T20" fmla="*/ 777 w 3054"/>
                <a:gd name="T21" fmla="*/ 164 h 878"/>
                <a:gd name="T22" fmla="*/ 877 w 3054"/>
                <a:gd name="T23" fmla="*/ 164 h 878"/>
                <a:gd name="T24" fmla="*/ 881 w 3054"/>
                <a:gd name="T25" fmla="*/ 197 h 878"/>
                <a:gd name="T26" fmla="*/ 907 w 3054"/>
                <a:gd name="T27" fmla="*/ 231 h 878"/>
                <a:gd name="T28" fmla="*/ 993 w 3054"/>
                <a:gd name="T29" fmla="*/ 261 h 878"/>
                <a:gd name="T30" fmla="*/ 1107 w 3054"/>
                <a:gd name="T31" fmla="*/ 297 h 878"/>
                <a:gd name="T32" fmla="*/ 1127 w 3054"/>
                <a:gd name="T33" fmla="*/ 327 h 878"/>
                <a:gd name="T34" fmla="*/ 1170 w 3054"/>
                <a:gd name="T35" fmla="*/ 357 h 878"/>
                <a:gd name="T36" fmla="*/ 1250 w 3054"/>
                <a:gd name="T37" fmla="*/ 393 h 878"/>
                <a:gd name="T38" fmla="*/ 1374 w 3054"/>
                <a:gd name="T39" fmla="*/ 393 h 878"/>
                <a:gd name="T40" fmla="*/ 1534 w 3054"/>
                <a:gd name="T41" fmla="*/ 427 h 878"/>
                <a:gd name="T42" fmla="*/ 1538 w 3054"/>
                <a:gd name="T43" fmla="*/ 461 h 878"/>
                <a:gd name="T44" fmla="*/ 1566 w 3054"/>
                <a:gd name="T45" fmla="*/ 461 h 878"/>
                <a:gd name="T46" fmla="*/ 1624 w 3054"/>
                <a:gd name="T47" fmla="*/ 497 h 878"/>
                <a:gd name="T48" fmla="*/ 1634 w 3054"/>
                <a:gd name="T49" fmla="*/ 531 h 878"/>
                <a:gd name="T50" fmla="*/ 1650 w 3054"/>
                <a:gd name="T51" fmla="*/ 531 h 878"/>
                <a:gd name="T52" fmla="*/ 1674 w 3054"/>
                <a:gd name="T53" fmla="*/ 531 h 878"/>
                <a:gd name="T54" fmla="*/ 1770 w 3054"/>
                <a:gd name="T55" fmla="*/ 531 h 878"/>
                <a:gd name="T56" fmla="*/ 1792 w 3054"/>
                <a:gd name="T57" fmla="*/ 531 h 878"/>
                <a:gd name="T58" fmla="*/ 1873 w 3054"/>
                <a:gd name="T59" fmla="*/ 531 h 878"/>
                <a:gd name="T60" fmla="*/ 1923 w 3054"/>
                <a:gd name="T61" fmla="*/ 531 h 878"/>
                <a:gd name="T62" fmla="*/ 1931 w 3054"/>
                <a:gd name="T63" fmla="*/ 531 h 878"/>
                <a:gd name="T64" fmla="*/ 1965 w 3054"/>
                <a:gd name="T65" fmla="*/ 531 h 878"/>
                <a:gd name="T66" fmla="*/ 1985 w 3054"/>
                <a:gd name="T67" fmla="*/ 531 h 878"/>
                <a:gd name="T68" fmla="*/ 2105 w 3054"/>
                <a:gd name="T69" fmla="*/ 531 h 878"/>
                <a:gd name="T70" fmla="*/ 2201 w 3054"/>
                <a:gd name="T71" fmla="*/ 531 h 878"/>
                <a:gd name="T72" fmla="*/ 2235 w 3054"/>
                <a:gd name="T73" fmla="*/ 636 h 878"/>
                <a:gd name="T74" fmla="*/ 2339 w 3054"/>
                <a:gd name="T75" fmla="*/ 636 h 878"/>
                <a:gd name="T76" fmla="*/ 2365 w 3054"/>
                <a:gd name="T77" fmla="*/ 636 h 878"/>
                <a:gd name="T78" fmla="*/ 2445 w 3054"/>
                <a:gd name="T79" fmla="*/ 636 h 878"/>
                <a:gd name="T80" fmla="*/ 2612 w 3054"/>
                <a:gd name="T81" fmla="*/ 636 h 878"/>
                <a:gd name="T82" fmla="*/ 2638 w 3054"/>
                <a:gd name="T83" fmla="*/ 878 h 878"/>
                <a:gd name="T84" fmla="*/ 3054 w 3054"/>
                <a:gd name="T85" fmla="*/ 878 h 8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3054" h="878">
                  <a:moveTo>
                    <a:pt x="0" y="0"/>
                  </a:moveTo>
                  <a:lnTo>
                    <a:pt x="4" y="0"/>
                  </a:lnTo>
                  <a:lnTo>
                    <a:pt x="62" y="0"/>
                  </a:lnTo>
                  <a:lnTo>
                    <a:pt x="74" y="0"/>
                  </a:lnTo>
                  <a:lnTo>
                    <a:pt x="74" y="26"/>
                  </a:lnTo>
                  <a:lnTo>
                    <a:pt x="104" y="26"/>
                  </a:lnTo>
                  <a:lnTo>
                    <a:pt x="104" y="54"/>
                  </a:lnTo>
                  <a:lnTo>
                    <a:pt x="108" y="54"/>
                  </a:lnTo>
                  <a:lnTo>
                    <a:pt x="108" y="80"/>
                  </a:lnTo>
                  <a:lnTo>
                    <a:pt x="112" y="80"/>
                  </a:lnTo>
                  <a:lnTo>
                    <a:pt x="120" y="80"/>
                  </a:lnTo>
                  <a:lnTo>
                    <a:pt x="120" y="108"/>
                  </a:lnTo>
                  <a:lnTo>
                    <a:pt x="254" y="108"/>
                  </a:lnTo>
                  <a:lnTo>
                    <a:pt x="254" y="134"/>
                  </a:lnTo>
                  <a:lnTo>
                    <a:pt x="334" y="134"/>
                  </a:lnTo>
                  <a:lnTo>
                    <a:pt x="338" y="134"/>
                  </a:lnTo>
                  <a:lnTo>
                    <a:pt x="338" y="164"/>
                  </a:lnTo>
                  <a:lnTo>
                    <a:pt x="392" y="164"/>
                  </a:lnTo>
                  <a:lnTo>
                    <a:pt x="404" y="164"/>
                  </a:lnTo>
                  <a:lnTo>
                    <a:pt x="458" y="164"/>
                  </a:lnTo>
                  <a:lnTo>
                    <a:pt x="663" y="164"/>
                  </a:lnTo>
                  <a:lnTo>
                    <a:pt x="777" y="164"/>
                  </a:lnTo>
                  <a:lnTo>
                    <a:pt x="855" y="164"/>
                  </a:lnTo>
                  <a:lnTo>
                    <a:pt x="877" y="164"/>
                  </a:lnTo>
                  <a:lnTo>
                    <a:pt x="881" y="164"/>
                  </a:lnTo>
                  <a:lnTo>
                    <a:pt x="881" y="197"/>
                  </a:lnTo>
                  <a:lnTo>
                    <a:pt x="907" y="197"/>
                  </a:lnTo>
                  <a:lnTo>
                    <a:pt x="907" y="231"/>
                  </a:lnTo>
                  <a:lnTo>
                    <a:pt x="993" y="231"/>
                  </a:lnTo>
                  <a:lnTo>
                    <a:pt x="993" y="261"/>
                  </a:lnTo>
                  <a:lnTo>
                    <a:pt x="1107" y="261"/>
                  </a:lnTo>
                  <a:lnTo>
                    <a:pt x="1107" y="297"/>
                  </a:lnTo>
                  <a:lnTo>
                    <a:pt x="1127" y="297"/>
                  </a:lnTo>
                  <a:lnTo>
                    <a:pt x="1127" y="327"/>
                  </a:lnTo>
                  <a:lnTo>
                    <a:pt x="1170" y="327"/>
                  </a:lnTo>
                  <a:lnTo>
                    <a:pt x="1170" y="357"/>
                  </a:lnTo>
                  <a:lnTo>
                    <a:pt x="1250" y="357"/>
                  </a:lnTo>
                  <a:lnTo>
                    <a:pt x="1250" y="393"/>
                  </a:lnTo>
                  <a:lnTo>
                    <a:pt x="1320" y="393"/>
                  </a:lnTo>
                  <a:lnTo>
                    <a:pt x="1374" y="393"/>
                  </a:lnTo>
                  <a:lnTo>
                    <a:pt x="1534" y="393"/>
                  </a:lnTo>
                  <a:lnTo>
                    <a:pt x="1534" y="427"/>
                  </a:lnTo>
                  <a:lnTo>
                    <a:pt x="1538" y="427"/>
                  </a:lnTo>
                  <a:lnTo>
                    <a:pt x="1538" y="461"/>
                  </a:lnTo>
                  <a:lnTo>
                    <a:pt x="1554" y="461"/>
                  </a:lnTo>
                  <a:lnTo>
                    <a:pt x="1566" y="461"/>
                  </a:lnTo>
                  <a:lnTo>
                    <a:pt x="1624" y="461"/>
                  </a:lnTo>
                  <a:lnTo>
                    <a:pt x="1624" y="497"/>
                  </a:lnTo>
                  <a:lnTo>
                    <a:pt x="1634" y="497"/>
                  </a:lnTo>
                  <a:lnTo>
                    <a:pt x="1634" y="531"/>
                  </a:lnTo>
                  <a:lnTo>
                    <a:pt x="1646" y="531"/>
                  </a:lnTo>
                  <a:lnTo>
                    <a:pt x="1650" y="531"/>
                  </a:lnTo>
                  <a:lnTo>
                    <a:pt x="1658" y="531"/>
                  </a:lnTo>
                  <a:lnTo>
                    <a:pt x="1674" y="531"/>
                  </a:lnTo>
                  <a:lnTo>
                    <a:pt x="1696" y="531"/>
                  </a:lnTo>
                  <a:lnTo>
                    <a:pt x="1770" y="531"/>
                  </a:lnTo>
                  <a:lnTo>
                    <a:pt x="1776" y="531"/>
                  </a:lnTo>
                  <a:lnTo>
                    <a:pt x="1792" y="531"/>
                  </a:lnTo>
                  <a:lnTo>
                    <a:pt x="1869" y="531"/>
                  </a:lnTo>
                  <a:lnTo>
                    <a:pt x="1873" y="531"/>
                  </a:lnTo>
                  <a:lnTo>
                    <a:pt x="1881" y="531"/>
                  </a:lnTo>
                  <a:lnTo>
                    <a:pt x="1923" y="531"/>
                  </a:lnTo>
                  <a:lnTo>
                    <a:pt x="1927" y="531"/>
                  </a:lnTo>
                  <a:lnTo>
                    <a:pt x="1931" y="531"/>
                  </a:lnTo>
                  <a:lnTo>
                    <a:pt x="1959" y="531"/>
                  </a:lnTo>
                  <a:lnTo>
                    <a:pt x="1965" y="531"/>
                  </a:lnTo>
                  <a:lnTo>
                    <a:pt x="1981" y="531"/>
                  </a:lnTo>
                  <a:lnTo>
                    <a:pt x="1985" y="531"/>
                  </a:lnTo>
                  <a:lnTo>
                    <a:pt x="2085" y="531"/>
                  </a:lnTo>
                  <a:lnTo>
                    <a:pt x="2105" y="531"/>
                  </a:lnTo>
                  <a:lnTo>
                    <a:pt x="2147" y="531"/>
                  </a:lnTo>
                  <a:lnTo>
                    <a:pt x="2201" y="531"/>
                  </a:lnTo>
                  <a:lnTo>
                    <a:pt x="2235" y="531"/>
                  </a:lnTo>
                  <a:lnTo>
                    <a:pt x="2235" y="636"/>
                  </a:lnTo>
                  <a:lnTo>
                    <a:pt x="2319" y="636"/>
                  </a:lnTo>
                  <a:lnTo>
                    <a:pt x="2339" y="636"/>
                  </a:lnTo>
                  <a:lnTo>
                    <a:pt x="2343" y="636"/>
                  </a:lnTo>
                  <a:lnTo>
                    <a:pt x="2365" y="636"/>
                  </a:lnTo>
                  <a:lnTo>
                    <a:pt x="2419" y="636"/>
                  </a:lnTo>
                  <a:lnTo>
                    <a:pt x="2445" y="636"/>
                  </a:lnTo>
                  <a:lnTo>
                    <a:pt x="2546" y="636"/>
                  </a:lnTo>
                  <a:lnTo>
                    <a:pt x="2612" y="636"/>
                  </a:lnTo>
                  <a:lnTo>
                    <a:pt x="2612" y="878"/>
                  </a:lnTo>
                  <a:lnTo>
                    <a:pt x="2638" y="878"/>
                  </a:lnTo>
                  <a:lnTo>
                    <a:pt x="2724" y="878"/>
                  </a:lnTo>
                  <a:lnTo>
                    <a:pt x="3054" y="878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E6D39931-6548-4AE3-9034-CD3B68FE6692}"/>
              </a:ext>
            </a:extLst>
          </p:cNvPr>
          <p:cNvGrpSpPr/>
          <p:nvPr/>
        </p:nvGrpSpPr>
        <p:grpSpPr>
          <a:xfrm>
            <a:off x="3786188" y="1501775"/>
            <a:ext cx="5211762" cy="1412875"/>
            <a:chOff x="3786188" y="1501775"/>
            <a:chExt cx="5211762" cy="1412875"/>
          </a:xfrm>
        </p:grpSpPr>
        <p:grpSp>
          <p:nvGrpSpPr>
            <p:cNvPr id="188" name="Group 187">
              <a:extLst>
                <a:ext uri="{FF2B5EF4-FFF2-40B4-BE49-F238E27FC236}">
                  <a16:creationId xmlns:a16="http://schemas.microsoft.com/office/drawing/2014/main" id="{8290148E-61BF-44FF-989D-824B93133C2D}"/>
                </a:ext>
              </a:extLst>
            </p:cNvPr>
            <p:cNvGrpSpPr/>
            <p:nvPr/>
          </p:nvGrpSpPr>
          <p:grpSpPr>
            <a:xfrm>
              <a:off x="3786188" y="1501775"/>
              <a:ext cx="5211762" cy="1412875"/>
              <a:chOff x="3786188" y="1501775"/>
              <a:chExt cx="5211762" cy="1412875"/>
            </a:xfrm>
          </p:grpSpPr>
          <p:sp>
            <p:nvSpPr>
              <p:cNvPr id="89" name="Line 86">
                <a:extLst>
                  <a:ext uri="{FF2B5EF4-FFF2-40B4-BE49-F238E27FC236}">
                    <a16:creationId xmlns:a16="http://schemas.microsoft.com/office/drawing/2014/main" id="{33047D25-F9D8-4BE2-BD63-6AE24463CA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95713" y="1524000"/>
                <a:ext cx="25400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Line 87">
                <a:extLst>
                  <a:ext uri="{FF2B5EF4-FFF2-40B4-BE49-F238E27FC236}">
                    <a16:creationId xmlns:a16="http://schemas.microsoft.com/office/drawing/2014/main" id="{C03A262A-8A13-487D-AEF8-25FFF7F4DB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8413" y="1511300"/>
                <a:ext cx="0" cy="2540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Line 146">
                <a:extLst>
                  <a:ext uri="{FF2B5EF4-FFF2-40B4-BE49-F238E27FC236}">
                    <a16:creationId xmlns:a16="http://schemas.microsoft.com/office/drawing/2014/main" id="{1373ECDE-B1AB-49BB-9FBC-F154A352CF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86188" y="152400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0" name="Line 147">
                <a:extLst>
                  <a:ext uri="{FF2B5EF4-FFF2-40B4-BE49-F238E27FC236}">
                    <a16:creationId xmlns:a16="http://schemas.microsoft.com/office/drawing/2014/main" id="{111F237E-9C95-4385-A834-C86AE125ED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8413" y="1511300"/>
                <a:ext cx="0" cy="2540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Line 148">
                <a:extLst>
                  <a:ext uri="{FF2B5EF4-FFF2-40B4-BE49-F238E27FC236}">
                    <a16:creationId xmlns:a16="http://schemas.microsoft.com/office/drawing/2014/main" id="{009A220B-6D4C-4CEB-8A5B-B71AC99179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8413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2" name="Line 149">
                <a:extLst>
                  <a:ext uri="{FF2B5EF4-FFF2-40B4-BE49-F238E27FC236}">
                    <a16:creationId xmlns:a16="http://schemas.microsoft.com/office/drawing/2014/main" id="{E0666115-F2CB-4AFA-8A11-4B951AC1B3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98913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3" name="Line 150">
                <a:extLst>
                  <a:ext uri="{FF2B5EF4-FFF2-40B4-BE49-F238E27FC236}">
                    <a16:creationId xmlns:a16="http://schemas.microsoft.com/office/drawing/2014/main" id="{556BA3AD-4B9F-401A-8423-1905694FF3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1313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4" name="Line 151">
                <a:extLst>
                  <a:ext uri="{FF2B5EF4-FFF2-40B4-BE49-F238E27FC236}">
                    <a16:creationId xmlns:a16="http://schemas.microsoft.com/office/drawing/2014/main" id="{1066A56E-2A45-4E73-8D80-AB130FF6FA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7663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5" name="Line 152">
                <a:extLst>
                  <a:ext uri="{FF2B5EF4-FFF2-40B4-BE49-F238E27FC236}">
                    <a16:creationId xmlns:a16="http://schemas.microsoft.com/office/drawing/2014/main" id="{FCF479AC-032A-4DF9-BD50-67B8A43493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24400" y="189706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6" name="Line 153">
                <a:extLst>
                  <a:ext uri="{FF2B5EF4-FFF2-40B4-BE49-F238E27FC236}">
                    <a16:creationId xmlns:a16="http://schemas.microsoft.com/office/drawing/2014/main" id="{9918F6D9-C917-4BF1-89AA-B6933EC8F9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02200" y="189706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7" name="Line 154">
                <a:extLst>
                  <a:ext uri="{FF2B5EF4-FFF2-40B4-BE49-F238E27FC236}">
                    <a16:creationId xmlns:a16="http://schemas.microsoft.com/office/drawing/2014/main" id="{46E5DEB3-C7E7-411C-A2D8-A9ADE9104D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76913" y="223361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8" name="Line 155">
                <a:extLst>
                  <a:ext uri="{FF2B5EF4-FFF2-40B4-BE49-F238E27FC236}">
                    <a16:creationId xmlns:a16="http://schemas.microsoft.com/office/drawing/2014/main" id="{6C628F9C-4380-40CA-812C-BC53CA828B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57913" y="2411413"/>
                <a:ext cx="0" cy="460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" name="Line 156">
                <a:extLst>
                  <a:ext uri="{FF2B5EF4-FFF2-40B4-BE49-F238E27FC236}">
                    <a16:creationId xmlns:a16="http://schemas.microsoft.com/office/drawing/2014/main" id="{4E0809D3-DF1B-47AA-BFC8-FE7EAD0614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10313" y="2411413"/>
                <a:ext cx="0" cy="460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" name="Line 157">
                <a:extLst>
                  <a:ext uri="{FF2B5EF4-FFF2-40B4-BE49-F238E27FC236}">
                    <a16:creationId xmlns:a16="http://schemas.microsoft.com/office/drawing/2014/main" id="{05D079BD-D267-43C5-8ED9-61D732A93B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1438" y="2411413"/>
                <a:ext cx="0" cy="460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" name="Line 158">
                <a:extLst>
                  <a:ext uri="{FF2B5EF4-FFF2-40B4-BE49-F238E27FC236}">
                    <a16:creationId xmlns:a16="http://schemas.microsoft.com/office/drawing/2014/main" id="{F980A52C-010A-49F2-BCC8-1B75428DDB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434138" y="2433638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" name="Line 159">
                <a:extLst>
                  <a:ext uri="{FF2B5EF4-FFF2-40B4-BE49-F238E27FC236}">
                    <a16:creationId xmlns:a16="http://schemas.microsoft.com/office/drawing/2014/main" id="{70B62AA9-D4F6-45D7-B6DD-768107743E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59538" y="2411413"/>
                <a:ext cx="0" cy="460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" name="Line 160">
                <a:extLst>
                  <a:ext uri="{FF2B5EF4-FFF2-40B4-BE49-F238E27FC236}">
                    <a16:creationId xmlns:a16="http://schemas.microsoft.com/office/drawing/2014/main" id="{08F2662B-14BC-41FC-A80D-CC3B1AD97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99238" y="25209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" name="Line 161">
                <a:extLst>
                  <a:ext uri="{FF2B5EF4-FFF2-40B4-BE49-F238E27FC236}">
                    <a16:creationId xmlns:a16="http://schemas.microsoft.com/office/drawing/2014/main" id="{25B9D82C-75A7-4038-9474-B65ED589BD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75450" y="25209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" name="Line 162">
                <a:extLst>
                  <a:ext uri="{FF2B5EF4-FFF2-40B4-BE49-F238E27FC236}">
                    <a16:creationId xmlns:a16="http://schemas.microsoft.com/office/drawing/2014/main" id="{25BB6CB5-FFC3-4231-B85B-9D1F98B3BF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00850" y="2520950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" name="Line 163">
                <a:extLst>
                  <a:ext uri="{FF2B5EF4-FFF2-40B4-BE49-F238E27FC236}">
                    <a16:creationId xmlns:a16="http://schemas.microsoft.com/office/drawing/2014/main" id="{18DFCE92-928E-49E0-8970-1AB10917C6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797675" y="2673350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" name="Line 164">
                <a:extLst>
                  <a:ext uri="{FF2B5EF4-FFF2-40B4-BE49-F238E27FC236}">
                    <a16:creationId xmlns:a16="http://schemas.microsoft.com/office/drawing/2014/main" id="{FC5AAF68-B7FC-4F71-8535-912659B9C3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19900" y="26511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8" name="Line 165">
                <a:extLst>
                  <a:ext uri="{FF2B5EF4-FFF2-40B4-BE49-F238E27FC236}">
                    <a16:creationId xmlns:a16="http://schemas.microsoft.com/office/drawing/2014/main" id="{D0F5BFF1-9ADD-43E1-9E11-C22C898DB4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61175" y="26511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9" name="Line 166">
                <a:extLst>
                  <a:ext uri="{FF2B5EF4-FFF2-40B4-BE49-F238E27FC236}">
                    <a16:creationId xmlns:a16="http://schemas.microsoft.com/office/drawing/2014/main" id="{385BC7AB-5EB4-4602-9163-D8D41C191F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11975" y="26511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0" name="Line 167">
                <a:extLst>
                  <a:ext uri="{FF2B5EF4-FFF2-40B4-BE49-F238E27FC236}">
                    <a16:creationId xmlns:a16="http://schemas.microsoft.com/office/drawing/2014/main" id="{95E5664E-FA8A-4A99-8D1A-4E00317E58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85000" y="26511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1" name="Line 168">
                <a:extLst>
                  <a:ext uri="{FF2B5EF4-FFF2-40B4-BE49-F238E27FC236}">
                    <a16:creationId xmlns:a16="http://schemas.microsoft.com/office/drawing/2014/main" id="{DFC480F4-469F-4DA5-9391-D2166FC2F9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4400" y="26511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2" name="Line 169">
                <a:extLst>
                  <a:ext uri="{FF2B5EF4-FFF2-40B4-BE49-F238E27FC236}">
                    <a16:creationId xmlns:a16="http://schemas.microsoft.com/office/drawing/2014/main" id="{952CC88B-C7B4-4AB1-976F-01B5891187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16800" y="265112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3" name="Line 170">
                <a:extLst>
                  <a:ext uri="{FF2B5EF4-FFF2-40B4-BE49-F238E27FC236}">
                    <a16:creationId xmlns:a16="http://schemas.microsoft.com/office/drawing/2014/main" id="{79D06076-BE78-4797-B8A4-5B582A7F5D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454900" y="2892425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4" name="Line 171">
                <a:extLst>
                  <a:ext uri="{FF2B5EF4-FFF2-40B4-BE49-F238E27FC236}">
                    <a16:creationId xmlns:a16="http://schemas.microsoft.com/office/drawing/2014/main" id="{A33886D3-8A9B-4673-BAF0-9A8708BC25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77125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5" name="Line 172">
                <a:extLst>
                  <a:ext uri="{FF2B5EF4-FFF2-40B4-BE49-F238E27FC236}">
                    <a16:creationId xmlns:a16="http://schemas.microsoft.com/office/drawing/2014/main" id="{596DBBF9-8BA3-4050-AF0E-2C127F1A8A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83500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6" name="Line 173">
                <a:extLst>
                  <a:ext uri="{FF2B5EF4-FFF2-40B4-BE49-F238E27FC236}">
                    <a16:creationId xmlns:a16="http://schemas.microsoft.com/office/drawing/2014/main" id="{4671ACC7-3CB7-496C-A90E-A6A5797053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83513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7" name="Line 174">
                <a:extLst>
                  <a:ext uri="{FF2B5EF4-FFF2-40B4-BE49-F238E27FC236}">
                    <a16:creationId xmlns:a16="http://schemas.microsoft.com/office/drawing/2014/main" id="{165A6864-9EB3-4419-9D21-6CBB4A1E15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75588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8" name="Line 175">
                <a:extLst>
                  <a:ext uri="{FF2B5EF4-FFF2-40B4-BE49-F238E27FC236}">
                    <a16:creationId xmlns:a16="http://schemas.microsoft.com/office/drawing/2014/main" id="{75EB418A-CA36-4C00-A651-8BF86404D2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77288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9" name="Line 176">
                <a:extLst>
                  <a:ext uri="{FF2B5EF4-FFF2-40B4-BE49-F238E27FC236}">
                    <a16:creationId xmlns:a16="http://schemas.microsoft.com/office/drawing/2014/main" id="{AF805323-B5CE-4C86-B8CF-8428DD2164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96338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0" name="Line 177">
                <a:extLst>
                  <a:ext uri="{FF2B5EF4-FFF2-40B4-BE49-F238E27FC236}">
                    <a16:creationId xmlns:a16="http://schemas.microsoft.com/office/drawing/2014/main" id="{4DA71B8F-2831-4A25-BB33-58CC9C8AA3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950325" y="2892425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1" name="Line 178">
                <a:extLst>
                  <a:ext uri="{FF2B5EF4-FFF2-40B4-BE49-F238E27FC236}">
                    <a16:creationId xmlns:a16="http://schemas.microsoft.com/office/drawing/2014/main" id="{F8583F53-7381-44B5-A439-2440DB785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5725" y="2870200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85" name="Freeform 182">
              <a:extLst>
                <a:ext uri="{FF2B5EF4-FFF2-40B4-BE49-F238E27FC236}">
                  <a16:creationId xmlns:a16="http://schemas.microsoft.com/office/drawing/2014/main" id="{389E927C-B7F7-49C8-B466-9808FAB12C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2063" y="1524000"/>
              <a:ext cx="5173663" cy="1368425"/>
            </a:xfrm>
            <a:custGeom>
              <a:avLst/>
              <a:gdLst>
                <a:gd name="T0" fmla="*/ 0 w 3259"/>
                <a:gd name="T1" fmla="*/ 0 h 862"/>
                <a:gd name="T2" fmla="*/ 4 w 3259"/>
                <a:gd name="T3" fmla="*/ 0 h 862"/>
                <a:gd name="T4" fmla="*/ 124 w 3259"/>
                <a:gd name="T5" fmla="*/ 0 h 862"/>
                <a:gd name="T6" fmla="*/ 220 w 3259"/>
                <a:gd name="T7" fmla="*/ 0 h 862"/>
                <a:gd name="T8" fmla="*/ 224 w 3259"/>
                <a:gd name="T9" fmla="*/ 0 h 862"/>
                <a:gd name="T10" fmla="*/ 274 w 3259"/>
                <a:gd name="T11" fmla="*/ 0 h 862"/>
                <a:gd name="T12" fmla="*/ 274 w 3259"/>
                <a:gd name="T13" fmla="*/ 50 h 862"/>
                <a:gd name="T14" fmla="*/ 362 w 3259"/>
                <a:gd name="T15" fmla="*/ 50 h 862"/>
                <a:gd name="T16" fmla="*/ 362 w 3259"/>
                <a:gd name="T17" fmla="*/ 100 h 862"/>
                <a:gd name="T18" fmla="*/ 434 w 3259"/>
                <a:gd name="T19" fmla="*/ 100 h 862"/>
                <a:gd name="T20" fmla="*/ 434 w 3259"/>
                <a:gd name="T21" fmla="*/ 150 h 862"/>
                <a:gd name="T22" fmla="*/ 438 w 3259"/>
                <a:gd name="T23" fmla="*/ 150 h 862"/>
                <a:gd name="T24" fmla="*/ 438 w 3259"/>
                <a:gd name="T25" fmla="*/ 201 h 862"/>
                <a:gd name="T26" fmla="*/ 547 w 3259"/>
                <a:gd name="T27" fmla="*/ 201 h 862"/>
                <a:gd name="T28" fmla="*/ 547 w 3259"/>
                <a:gd name="T29" fmla="*/ 251 h 862"/>
                <a:gd name="T30" fmla="*/ 581 w 3259"/>
                <a:gd name="T31" fmla="*/ 251 h 862"/>
                <a:gd name="T32" fmla="*/ 693 w 3259"/>
                <a:gd name="T33" fmla="*/ 251 h 862"/>
                <a:gd name="T34" fmla="*/ 801 w 3259"/>
                <a:gd name="T35" fmla="*/ 251 h 862"/>
                <a:gd name="T36" fmla="*/ 801 w 3259"/>
                <a:gd name="T37" fmla="*/ 305 h 862"/>
                <a:gd name="T38" fmla="*/ 907 w 3259"/>
                <a:gd name="T39" fmla="*/ 305 h 862"/>
                <a:gd name="T40" fmla="*/ 907 w 3259"/>
                <a:gd name="T41" fmla="*/ 355 h 862"/>
                <a:gd name="T42" fmla="*/ 969 w 3259"/>
                <a:gd name="T43" fmla="*/ 355 h 862"/>
                <a:gd name="T44" fmla="*/ 969 w 3259"/>
                <a:gd name="T45" fmla="*/ 407 h 862"/>
                <a:gd name="T46" fmla="*/ 1162 w 3259"/>
                <a:gd name="T47" fmla="*/ 407 h 862"/>
                <a:gd name="T48" fmla="*/ 1162 w 3259"/>
                <a:gd name="T49" fmla="*/ 461 h 862"/>
                <a:gd name="T50" fmla="*/ 1244 w 3259"/>
                <a:gd name="T51" fmla="*/ 461 h 862"/>
                <a:gd name="T52" fmla="*/ 1296 w 3259"/>
                <a:gd name="T53" fmla="*/ 461 h 862"/>
                <a:gd name="T54" fmla="*/ 1296 w 3259"/>
                <a:gd name="T55" fmla="*/ 519 h 862"/>
                <a:gd name="T56" fmla="*/ 1346 w 3259"/>
                <a:gd name="T57" fmla="*/ 519 h 862"/>
                <a:gd name="T58" fmla="*/ 1346 w 3259"/>
                <a:gd name="T59" fmla="*/ 573 h 862"/>
                <a:gd name="T60" fmla="*/ 1484 w 3259"/>
                <a:gd name="T61" fmla="*/ 573 h 862"/>
                <a:gd name="T62" fmla="*/ 1580 w 3259"/>
                <a:gd name="T63" fmla="*/ 573 h 862"/>
                <a:gd name="T64" fmla="*/ 1650 w 3259"/>
                <a:gd name="T65" fmla="*/ 573 h 862"/>
                <a:gd name="T66" fmla="*/ 1674 w 3259"/>
                <a:gd name="T67" fmla="*/ 573 h 862"/>
                <a:gd name="T68" fmla="*/ 1676 w 3259"/>
                <a:gd name="T69" fmla="*/ 573 h 862"/>
                <a:gd name="T70" fmla="*/ 1676 w 3259"/>
                <a:gd name="T71" fmla="*/ 644 h 862"/>
                <a:gd name="T72" fmla="*/ 1762 w 3259"/>
                <a:gd name="T73" fmla="*/ 644 h 862"/>
                <a:gd name="T74" fmla="*/ 1873 w 3259"/>
                <a:gd name="T75" fmla="*/ 644 h 862"/>
                <a:gd name="T76" fmla="*/ 1889 w 3259"/>
                <a:gd name="T77" fmla="*/ 644 h 862"/>
                <a:gd name="T78" fmla="*/ 1901 w 3259"/>
                <a:gd name="T79" fmla="*/ 644 h 862"/>
                <a:gd name="T80" fmla="*/ 1901 w 3259"/>
                <a:gd name="T81" fmla="*/ 724 h 862"/>
                <a:gd name="T82" fmla="*/ 1927 w 3259"/>
                <a:gd name="T83" fmla="*/ 724 h 862"/>
                <a:gd name="T84" fmla="*/ 1959 w 3259"/>
                <a:gd name="T85" fmla="*/ 724 h 862"/>
                <a:gd name="T86" fmla="*/ 2005 w 3259"/>
                <a:gd name="T87" fmla="*/ 724 h 862"/>
                <a:gd name="T88" fmla="*/ 2181 w 3259"/>
                <a:gd name="T89" fmla="*/ 724 h 862"/>
                <a:gd name="T90" fmla="*/ 2277 w 3259"/>
                <a:gd name="T91" fmla="*/ 724 h 862"/>
                <a:gd name="T92" fmla="*/ 2315 w 3259"/>
                <a:gd name="T93" fmla="*/ 724 h 862"/>
                <a:gd name="T94" fmla="*/ 2315 w 3259"/>
                <a:gd name="T95" fmla="*/ 862 h 862"/>
                <a:gd name="T96" fmla="*/ 2445 w 3259"/>
                <a:gd name="T97" fmla="*/ 862 h 862"/>
                <a:gd name="T98" fmla="*/ 2508 w 3259"/>
                <a:gd name="T99" fmla="*/ 862 h 862"/>
                <a:gd name="T100" fmla="*/ 2566 w 3259"/>
                <a:gd name="T101" fmla="*/ 862 h 862"/>
                <a:gd name="T102" fmla="*/ 3134 w 3259"/>
                <a:gd name="T103" fmla="*/ 862 h 862"/>
                <a:gd name="T104" fmla="*/ 3146 w 3259"/>
                <a:gd name="T105" fmla="*/ 862 h 862"/>
                <a:gd name="T106" fmla="*/ 3259 w 3259"/>
                <a:gd name="T107" fmla="*/ 862 h 8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3259" h="862">
                  <a:moveTo>
                    <a:pt x="0" y="0"/>
                  </a:moveTo>
                  <a:lnTo>
                    <a:pt x="4" y="0"/>
                  </a:lnTo>
                  <a:lnTo>
                    <a:pt x="124" y="0"/>
                  </a:lnTo>
                  <a:lnTo>
                    <a:pt x="220" y="0"/>
                  </a:lnTo>
                  <a:lnTo>
                    <a:pt x="224" y="0"/>
                  </a:lnTo>
                  <a:lnTo>
                    <a:pt x="274" y="0"/>
                  </a:lnTo>
                  <a:lnTo>
                    <a:pt x="274" y="50"/>
                  </a:lnTo>
                  <a:lnTo>
                    <a:pt x="362" y="50"/>
                  </a:lnTo>
                  <a:lnTo>
                    <a:pt x="362" y="100"/>
                  </a:lnTo>
                  <a:lnTo>
                    <a:pt x="434" y="100"/>
                  </a:lnTo>
                  <a:lnTo>
                    <a:pt x="434" y="150"/>
                  </a:lnTo>
                  <a:lnTo>
                    <a:pt x="438" y="150"/>
                  </a:lnTo>
                  <a:lnTo>
                    <a:pt x="438" y="201"/>
                  </a:lnTo>
                  <a:lnTo>
                    <a:pt x="547" y="201"/>
                  </a:lnTo>
                  <a:lnTo>
                    <a:pt x="547" y="251"/>
                  </a:lnTo>
                  <a:lnTo>
                    <a:pt x="581" y="251"/>
                  </a:lnTo>
                  <a:lnTo>
                    <a:pt x="693" y="251"/>
                  </a:lnTo>
                  <a:lnTo>
                    <a:pt x="801" y="251"/>
                  </a:lnTo>
                  <a:lnTo>
                    <a:pt x="801" y="305"/>
                  </a:lnTo>
                  <a:lnTo>
                    <a:pt x="907" y="305"/>
                  </a:lnTo>
                  <a:lnTo>
                    <a:pt x="907" y="355"/>
                  </a:lnTo>
                  <a:lnTo>
                    <a:pt x="969" y="355"/>
                  </a:lnTo>
                  <a:lnTo>
                    <a:pt x="969" y="407"/>
                  </a:lnTo>
                  <a:lnTo>
                    <a:pt x="1162" y="407"/>
                  </a:lnTo>
                  <a:lnTo>
                    <a:pt x="1162" y="461"/>
                  </a:lnTo>
                  <a:lnTo>
                    <a:pt x="1244" y="461"/>
                  </a:lnTo>
                  <a:lnTo>
                    <a:pt x="1296" y="461"/>
                  </a:lnTo>
                  <a:lnTo>
                    <a:pt x="1296" y="519"/>
                  </a:lnTo>
                  <a:lnTo>
                    <a:pt x="1346" y="519"/>
                  </a:lnTo>
                  <a:lnTo>
                    <a:pt x="1346" y="573"/>
                  </a:lnTo>
                  <a:lnTo>
                    <a:pt x="1484" y="573"/>
                  </a:lnTo>
                  <a:lnTo>
                    <a:pt x="1580" y="573"/>
                  </a:lnTo>
                  <a:lnTo>
                    <a:pt x="1650" y="573"/>
                  </a:lnTo>
                  <a:lnTo>
                    <a:pt x="1674" y="573"/>
                  </a:lnTo>
                  <a:lnTo>
                    <a:pt x="1676" y="573"/>
                  </a:lnTo>
                  <a:lnTo>
                    <a:pt x="1676" y="644"/>
                  </a:lnTo>
                  <a:lnTo>
                    <a:pt x="1762" y="644"/>
                  </a:lnTo>
                  <a:lnTo>
                    <a:pt x="1873" y="644"/>
                  </a:lnTo>
                  <a:lnTo>
                    <a:pt x="1889" y="644"/>
                  </a:lnTo>
                  <a:lnTo>
                    <a:pt x="1901" y="644"/>
                  </a:lnTo>
                  <a:lnTo>
                    <a:pt x="1901" y="724"/>
                  </a:lnTo>
                  <a:lnTo>
                    <a:pt x="1927" y="724"/>
                  </a:lnTo>
                  <a:lnTo>
                    <a:pt x="1959" y="724"/>
                  </a:lnTo>
                  <a:lnTo>
                    <a:pt x="2005" y="724"/>
                  </a:lnTo>
                  <a:lnTo>
                    <a:pt x="2181" y="724"/>
                  </a:lnTo>
                  <a:lnTo>
                    <a:pt x="2277" y="724"/>
                  </a:lnTo>
                  <a:lnTo>
                    <a:pt x="2315" y="724"/>
                  </a:lnTo>
                  <a:lnTo>
                    <a:pt x="2315" y="862"/>
                  </a:lnTo>
                  <a:lnTo>
                    <a:pt x="2445" y="862"/>
                  </a:lnTo>
                  <a:lnTo>
                    <a:pt x="2508" y="862"/>
                  </a:lnTo>
                  <a:lnTo>
                    <a:pt x="2566" y="862"/>
                  </a:lnTo>
                  <a:lnTo>
                    <a:pt x="3134" y="862"/>
                  </a:lnTo>
                  <a:lnTo>
                    <a:pt x="3146" y="862"/>
                  </a:lnTo>
                  <a:lnTo>
                    <a:pt x="3259" y="862"/>
                  </a:lnTo>
                </a:path>
              </a:pathLst>
            </a:custGeom>
            <a:noFill/>
            <a:ln w="19050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192" name="Rectangle 12">
            <a:extLst>
              <a:ext uri="{FF2B5EF4-FFF2-40B4-BE49-F238E27FC236}">
                <a16:creationId xmlns:a16="http://schemas.microsoft.com/office/drawing/2014/main" id="{32F930A2-DBC0-40EB-BDB6-391295504B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6414" y="4976292"/>
            <a:ext cx="113238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b="1" dirty="0"/>
              <a:t>Number at risk:</a:t>
            </a:r>
          </a:p>
        </p:txBody>
      </p:sp>
      <p:grpSp>
        <p:nvGrpSpPr>
          <p:cNvPr id="194" name="Group 193">
            <a:extLst>
              <a:ext uri="{FF2B5EF4-FFF2-40B4-BE49-F238E27FC236}">
                <a16:creationId xmlns:a16="http://schemas.microsoft.com/office/drawing/2014/main" id="{50F40972-B57D-44B1-AFCF-4B0A8BE5A376}"/>
              </a:ext>
            </a:extLst>
          </p:cNvPr>
          <p:cNvGrpSpPr/>
          <p:nvPr/>
        </p:nvGrpSpPr>
        <p:grpSpPr>
          <a:xfrm>
            <a:off x="3791804" y="3637557"/>
            <a:ext cx="360362" cy="71438"/>
            <a:chOff x="8666163" y="1733025"/>
            <a:chExt cx="360362" cy="71438"/>
          </a:xfrm>
        </p:grpSpPr>
        <p:grpSp>
          <p:nvGrpSpPr>
            <p:cNvPr id="195" name="Group 194">
              <a:extLst>
                <a:ext uri="{FF2B5EF4-FFF2-40B4-BE49-F238E27FC236}">
                  <a16:creationId xmlns:a16="http://schemas.microsoft.com/office/drawing/2014/main" id="{408D2253-E4ED-4FAD-A963-615EB9BAFE89}"/>
                </a:ext>
              </a:extLst>
            </p:cNvPr>
            <p:cNvGrpSpPr/>
            <p:nvPr/>
          </p:nvGrpSpPr>
          <p:grpSpPr>
            <a:xfrm>
              <a:off x="8731251" y="1733025"/>
              <a:ext cx="228600" cy="71438"/>
              <a:chOff x="9364663" y="1801813"/>
              <a:chExt cx="228600" cy="71438"/>
            </a:xfrm>
          </p:grpSpPr>
          <p:sp>
            <p:nvSpPr>
              <p:cNvPr id="197" name="Line 51">
                <a:extLst>
                  <a:ext uri="{FF2B5EF4-FFF2-40B4-BE49-F238E27FC236}">
                    <a16:creationId xmlns:a16="http://schemas.microsoft.com/office/drawing/2014/main" id="{8FF8FFD9-47C9-495D-A624-321A282692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46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8" name="Line 52">
                <a:extLst>
                  <a:ext uri="{FF2B5EF4-FFF2-40B4-BE49-F238E27FC236}">
                    <a16:creationId xmlns:a16="http://schemas.microsoft.com/office/drawing/2014/main" id="{0E490FB1-ECF4-4808-A7E9-80883FA371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480550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9" name="Line 53">
                <a:extLst>
                  <a:ext uri="{FF2B5EF4-FFF2-40B4-BE49-F238E27FC236}">
                    <a16:creationId xmlns:a16="http://schemas.microsoft.com/office/drawing/2014/main" id="{BD2E03CD-E37E-425F-BA38-E24A8C3538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932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96" name="Line 54">
              <a:extLst>
                <a:ext uri="{FF2B5EF4-FFF2-40B4-BE49-F238E27FC236}">
                  <a16:creationId xmlns:a16="http://schemas.microsoft.com/office/drawing/2014/main" id="{B000F7C5-C0BA-4107-B74D-75601CAF7E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66163" y="1771125"/>
              <a:ext cx="360362" cy="0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200" name="Group 199">
            <a:extLst>
              <a:ext uri="{FF2B5EF4-FFF2-40B4-BE49-F238E27FC236}">
                <a16:creationId xmlns:a16="http://schemas.microsoft.com/office/drawing/2014/main" id="{66712D53-8445-4E2A-8C72-501FE0B3BCD5}"/>
              </a:ext>
            </a:extLst>
          </p:cNvPr>
          <p:cNvGrpSpPr/>
          <p:nvPr/>
        </p:nvGrpSpPr>
        <p:grpSpPr>
          <a:xfrm>
            <a:off x="3791804" y="3915424"/>
            <a:ext cx="360362" cy="71438"/>
            <a:chOff x="8666163" y="1733025"/>
            <a:chExt cx="360362" cy="71438"/>
          </a:xfrm>
        </p:grpSpPr>
        <p:grpSp>
          <p:nvGrpSpPr>
            <p:cNvPr id="201" name="Group 200">
              <a:extLst>
                <a:ext uri="{FF2B5EF4-FFF2-40B4-BE49-F238E27FC236}">
                  <a16:creationId xmlns:a16="http://schemas.microsoft.com/office/drawing/2014/main" id="{26E7DD82-33EA-4922-B2DF-CAC4620FF47E}"/>
                </a:ext>
              </a:extLst>
            </p:cNvPr>
            <p:cNvGrpSpPr/>
            <p:nvPr/>
          </p:nvGrpSpPr>
          <p:grpSpPr>
            <a:xfrm>
              <a:off x="8731251" y="1733025"/>
              <a:ext cx="228600" cy="71438"/>
              <a:chOff x="9364663" y="1801813"/>
              <a:chExt cx="228600" cy="71438"/>
            </a:xfrm>
          </p:grpSpPr>
          <p:sp>
            <p:nvSpPr>
              <p:cNvPr id="203" name="Line 51">
                <a:extLst>
                  <a:ext uri="{FF2B5EF4-FFF2-40B4-BE49-F238E27FC236}">
                    <a16:creationId xmlns:a16="http://schemas.microsoft.com/office/drawing/2014/main" id="{A551025B-8530-4AC7-8EB4-0BBCB785A2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46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4" name="Line 52">
                <a:extLst>
                  <a:ext uri="{FF2B5EF4-FFF2-40B4-BE49-F238E27FC236}">
                    <a16:creationId xmlns:a16="http://schemas.microsoft.com/office/drawing/2014/main" id="{BF67D28B-CF69-4CB0-8D4C-175B20587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480550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5" name="Line 53">
                <a:extLst>
                  <a:ext uri="{FF2B5EF4-FFF2-40B4-BE49-F238E27FC236}">
                    <a16:creationId xmlns:a16="http://schemas.microsoft.com/office/drawing/2014/main" id="{55607495-A521-4791-BFCF-BE7501898D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932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202" name="Line 54">
              <a:extLst>
                <a:ext uri="{FF2B5EF4-FFF2-40B4-BE49-F238E27FC236}">
                  <a16:creationId xmlns:a16="http://schemas.microsoft.com/office/drawing/2014/main" id="{A8702BA7-4A57-4656-86F6-069F9485F4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66163" y="1771125"/>
              <a:ext cx="360362" cy="0"/>
            </a:xfrm>
            <a:prstGeom prst="line">
              <a:avLst/>
            </a:prstGeom>
            <a:noFill/>
            <a:ln w="19050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aphicFrame>
        <p:nvGraphicFramePr>
          <p:cNvPr id="206" name="Table 205">
            <a:extLst>
              <a:ext uri="{FF2B5EF4-FFF2-40B4-BE49-F238E27FC236}">
                <a16:creationId xmlns:a16="http://schemas.microsoft.com/office/drawing/2014/main" id="{08801136-D782-448A-9CB0-4DE530AC2B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8253583"/>
              </p:ext>
            </p:extLst>
          </p:nvPr>
        </p:nvGraphicFramePr>
        <p:xfrm>
          <a:off x="4137718" y="3227904"/>
          <a:ext cx="5143499" cy="853668"/>
        </p:xfrm>
        <a:graphic>
          <a:graphicData uri="http://schemas.openxmlformats.org/drawingml/2006/table">
            <a:tbl>
              <a:tblPr firstRow="1" bandRow="1"/>
              <a:tblGrid>
                <a:gridCol w="1478280">
                  <a:extLst>
                    <a:ext uri="{9D8B030D-6E8A-4147-A177-3AD203B41FA5}">
                      <a16:colId xmlns:a16="http://schemas.microsoft.com/office/drawing/2014/main" val="856427517"/>
                    </a:ext>
                  </a:extLst>
                </a:gridCol>
                <a:gridCol w="1043940">
                  <a:extLst>
                    <a:ext uri="{9D8B030D-6E8A-4147-A177-3AD203B41FA5}">
                      <a16:colId xmlns:a16="http://schemas.microsoft.com/office/drawing/2014/main" val="4179246454"/>
                    </a:ext>
                  </a:extLst>
                </a:gridCol>
                <a:gridCol w="2621279">
                  <a:extLst>
                    <a:ext uri="{9D8B030D-6E8A-4147-A177-3AD203B41FA5}">
                      <a16:colId xmlns:a16="http://schemas.microsoft.com/office/drawing/2014/main" val="3961210330"/>
                    </a:ext>
                  </a:extLst>
                </a:gridCol>
              </a:tblGrid>
              <a:tr h="301388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s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nths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4528241"/>
                  </a:ext>
                </a:extLst>
              </a:tr>
              <a:tr h="2761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 Prior Line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/70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030826"/>
                  </a:ext>
                </a:extLst>
              </a:tr>
              <a:tr h="2761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o Prior Lines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/42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804101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3FE7B4C9-71C8-43C9-8FAD-A662FA38558D}"/>
              </a:ext>
            </a:extLst>
          </p:cNvPr>
          <p:cNvSpPr txBox="1"/>
          <p:nvPr/>
        </p:nvSpPr>
        <p:spPr>
          <a:xfrm>
            <a:off x="1545631" y="6164826"/>
            <a:ext cx="9114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,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not estimable; PF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progression-free survival.</a:t>
            </a:r>
          </a:p>
        </p:txBody>
      </p:sp>
    </p:spTree>
    <p:extLst>
      <p:ext uri="{BB962C8B-B14F-4D97-AF65-F5344CB8AC3E}">
        <p14:creationId xmlns:p14="http://schemas.microsoft.com/office/powerpoint/2010/main" val="1549235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100</Words>
  <Application>Microsoft Office PowerPoint</Application>
  <PresentationFormat>Widescreen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wn Vahabzadeh, PharmD (MTM)</dc:creator>
  <cp:lastModifiedBy>Shawn Vahabzadeh, PharmD (MTM)</cp:lastModifiedBy>
  <cp:revision>83</cp:revision>
  <dcterms:created xsi:type="dcterms:W3CDTF">2018-07-18T19:14:30Z</dcterms:created>
  <dcterms:modified xsi:type="dcterms:W3CDTF">2020-05-01T19:37:36Z</dcterms:modified>
</cp:coreProperties>
</file>